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drawings/drawing2.xml" ContentType="application/vnd.openxmlformats-officedocument.drawingml.chartshapes+xml"/>
  <Override PartName="/ppt/charts/chart7.xml" ContentType="application/vnd.openxmlformats-officedocument.drawingml.chart+xml"/>
  <Override PartName="/ppt/drawings/drawing3.xml" ContentType="application/vnd.openxmlformats-officedocument.drawingml.chartshapes+xml"/>
  <Override PartName="/ppt/charts/chart8.xml" ContentType="application/vnd.openxmlformats-officedocument.drawingml.chart+xml"/>
  <Override PartName="/ppt/drawings/drawing4.xml" ContentType="application/vnd.openxmlformats-officedocument.drawingml.chartshapes+xml"/>
  <Override PartName="/ppt/charts/chart9.xml" ContentType="application/vnd.openxmlformats-officedocument.drawingml.chart+xml"/>
  <Override PartName="/ppt/drawings/drawing5.xml" ContentType="application/vnd.openxmlformats-officedocument.drawingml.chartshapes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11"/>
  </p:notesMasterIdLst>
  <p:sldIdLst>
    <p:sldId id="262" r:id="rId2"/>
    <p:sldId id="269" r:id="rId3"/>
    <p:sldId id="278" r:id="rId4"/>
    <p:sldId id="270" r:id="rId5"/>
    <p:sldId id="272" r:id="rId6"/>
    <p:sldId id="275" r:id="rId7"/>
    <p:sldId id="276" r:id="rId8"/>
    <p:sldId id="277" r:id="rId9"/>
    <p:sldId id="271" r:id="rId10"/>
  </p:sldIdLst>
  <p:sldSz cx="9144000" cy="6858000" type="screen4x3"/>
  <p:notesSz cx="7099300" cy="102346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1110" y="72"/>
      </p:cViewPr>
      <p:guideLst>
        <p:guide orient="horz" pos="2205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K:\kwpark%20from%20common%20pc\kye%20won%20022309\kye%20won\compds%20and%20Harmine%20derivatives\88%20copmds%20ppargs%20and%20aP2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wpark\Desktop\New%20MS\CFD\GW%20and%20PTs_ppar_ap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uji%20Kim\1)Metabolism%20research%20Lab\Results\CFD\CFD(NJ%20data)\(SJ)%2010T%20CFD%200248%20adipogene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uji%20Kim\1)Metabolism%20research%20Lab\Results\CFD\CFD(NJ%20data)\10T%20CFD%200248%20adipo2%20day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uji%20Kim\1)Metabolism%20research%20Lab\CFD%20study\2016.4.22%20C3aR%20siRNA%20Oil%20red%20O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Suji%20Kim\1)Metabolism%20research%20Lab\Results\RT-PCR\CFD\16.4.4%20CFDoverexp.%20C3aRago%20target%20gene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Suji%20Kim\1)Metabolism%20research%20Lab\Results\RT-PCR\CFD\16.4.4%20CFDoverexp.%20C3aRago%20target%20gene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D:\Suji%20Kim\1)Metabolism%20research%20Lab\Results\RT-PCR\CFD\16.4.4%20CFDoverexp.%20C3aRago%20target%20gene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D:\Suji%20Kim\1)Metabolism%20research%20Lab\Results\absorbance\16.4.6%20ccl9,%20c3aRago%20absorbance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D:\Suji%20Kim\1)Metabolism%20research%20Lab\Results\absorbance\16.4.6%20ccl9,%20c3aRago%20absorbanc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 b="0" i="1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r>
              <a:rPr lang="en-US" altLang="en-US" sz="1100" b="0" i="1" dirty="0" err="1" smtClean="0"/>
              <a:t>Ppar</a:t>
            </a:r>
            <a:r>
              <a:rPr lang="en-US" altLang="en-US" sz="1100" b="0" i="1" dirty="0" smtClean="0">
                <a:sym typeface="Symbol"/>
              </a:rPr>
              <a:t></a:t>
            </a:r>
            <a:endParaRPr lang="en-US" altLang="en-US" sz="1100" b="0" i="1" dirty="0"/>
          </a:p>
        </c:rich>
      </c:tx>
      <c:layout>
        <c:manualLayout>
          <c:xMode val="edge"/>
          <c:yMode val="edge"/>
          <c:x val="3.1866655311309187E-2"/>
          <c:y val="0.1898542582042827"/>
        </c:manualLayout>
      </c:layout>
      <c:overlay val="0"/>
      <c:spPr>
        <a:noFill/>
        <a:ln w="25400">
          <a:noFill/>
        </a:ln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12700">
              <a:solidFill>
                <a:srgbClr val="000000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1-C6A1-46B5-8509-C08A7D715B7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3-C6A1-46B5-8509-C08A7D715B78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 w="12700">
                <a:solidFill>
                  <a:srgbClr val="000000"/>
                </a:solidFill>
                <a:prstDash val="solid"/>
              </a:ln>
            </c:spPr>
            <c:extLst>
              <c:ext xmlns:c16="http://schemas.microsoft.com/office/drawing/2014/chart" uri="{C3380CC4-5D6E-409C-BE32-E72D297353CC}">
                <c16:uniqueId val="{00000005-C6A1-46B5-8509-C08A7D715B78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123:$J$160</c:f>
                <c:numCache>
                  <c:formatCode>General</c:formatCode>
                  <c:ptCount val="38"/>
                  <c:pt idx="0">
                    <c:v>0.11514947792766372</c:v>
                  </c:pt>
                  <c:pt idx="1">
                    <c:v>0.28448731957259782</c:v>
                  </c:pt>
                  <c:pt idx="2">
                    <c:v>4.2708252953103883E-2</c:v>
                  </c:pt>
                  <c:pt idx="3">
                    <c:v>6.226351139663245E-2</c:v>
                  </c:pt>
                  <c:pt idx="4">
                    <c:v>0.11060236701629426</c:v>
                  </c:pt>
                  <c:pt idx="5">
                    <c:v>4.3965021435042727E-3</c:v>
                  </c:pt>
                  <c:pt idx="6">
                    <c:v>8.9209549717177247E-2</c:v>
                  </c:pt>
                  <c:pt idx="7">
                    <c:v>3.7301490495076299E-2</c:v>
                  </c:pt>
                  <c:pt idx="8">
                    <c:v>0.24578567574771379</c:v>
                  </c:pt>
                  <c:pt idx="9">
                    <c:v>0.34452072331857081</c:v>
                  </c:pt>
                  <c:pt idx="10">
                    <c:v>4.8569342906578966E-2</c:v>
                  </c:pt>
                  <c:pt idx="11">
                    <c:v>1.8115637589638103E-2</c:v>
                  </c:pt>
                  <c:pt idx="12">
                    <c:v>1.0012638677197347E-3</c:v>
                  </c:pt>
                  <c:pt idx="13">
                    <c:v>3.3600113173168487E-2</c:v>
                  </c:pt>
                  <c:pt idx="14">
                    <c:v>5.295197460704093E-2</c:v>
                  </c:pt>
                  <c:pt idx="15">
                    <c:v>0.21216041745213196</c:v>
                  </c:pt>
                  <c:pt idx="16">
                    <c:v>5.1313382614255512E-2</c:v>
                  </c:pt>
                  <c:pt idx="17">
                    <c:v>0.19753495164321799</c:v>
                  </c:pt>
                  <c:pt idx="18">
                    <c:v>2.1194549897832368E-2</c:v>
                  </c:pt>
                  <c:pt idx="19">
                    <c:v>4.0672205721063226E-2</c:v>
                  </c:pt>
                  <c:pt idx="20">
                    <c:v>7.4206167504835214E-3</c:v>
                  </c:pt>
                  <c:pt idx="21">
                    <c:v>4.5561364650050402E-2</c:v>
                  </c:pt>
                  <c:pt idx="22">
                    <c:v>3.1545921345579563E-2</c:v>
                  </c:pt>
                  <c:pt idx="23">
                    <c:v>1.2693132722835963E-3</c:v>
                  </c:pt>
                  <c:pt idx="24">
                    <c:v>6.2896210420091234E-2</c:v>
                  </c:pt>
                  <c:pt idx="25">
                    <c:v>8.1845653116474237E-2</c:v>
                  </c:pt>
                  <c:pt idx="26">
                    <c:v>0.10622903372712122</c:v>
                  </c:pt>
                  <c:pt idx="27">
                    <c:v>1.6744386140654845E-2</c:v>
                  </c:pt>
                  <c:pt idx="28">
                    <c:v>4.3914108993379684E-2</c:v>
                  </c:pt>
                  <c:pt idx="29">
                    <c:v>0.25221930498415701</c:v>
                  </c:pt>
                  <c:pt idx="30">
                    <c:v>4.5747426527016515E-2</c:v>
                  </c:pt>
                  <c:pt idx="31">
                    <c:v>7.6005537208888335E-2</c:v>
                  </c:pt>
                  <c:pt idx="32">
                    <c:v>4.5149325026002607E-2</c:v>
                  </c:pt>
                  <c:pt idx="33">
                    <c:v>7.6553319464775754E-2</c:v>
                  </c:pt>
                  <c:pt idx="34">
                    <c:v>3.7105572803750819E-2</c:v>
                  </c:pt>
                  <c:pt idx="35">
                    <c:v>2.5900668240552181E-2</c:v>
                  </c:pt>
                  <c:pt idx="36">
                    <c:v>0.14463997410732601</c:v>
                  </c:pt>
                  <c:pt idx="37">
                    <c:v>0.13493852696327366</c:v>
                  </c:pt>
                </c:numCache>
              </c:numRef>
            </c:plus>
            <c:spPr>
              <a:ln w="1270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H$123:$H$160</c:f>
              <c:strCache>
                <c:ptCount val="38"/>
                <c:pt idx="0">
                  <c:v>DMSO</c:v>
                </c:pt>
                <c:pt idx="1">
                  <c:v>PHENMAIL</c:v>
                </c:pt>
                <c:pt idx="2">
                  <c:v>GW</c:v>
                </c:pt>
                <c:pt idx="3">
                  <c:v>PT1</c:v>
                </c:pt>
                <c:pt idx="4">
                  <c:v>PT2</c:v>
                </c:pt>
                <c:pt idx="5">
                  <c:v>PT3</c:v>
                </c:pt>
                <c:pt idx="6">
                  <c:v>PT4</c:v>
                </c:pt>
                <c:pt idx="7">
                  <c:v>PT5</c:v>
                </c:pt>
                <c:pt idx="8">
                  <c:v>PT6</c:v>
                </c:pt>
                <c:pt idx="9">
                  <c:v>PT7</c:v>
                </c:pt>
                <c:pt idx="10">
                  <c:v>PT8</c:v>
                </c:pt>
                <c:pt idx="11">
                  <c:v>PT9</c:v>
                </c:pt>
                <c:pt idx="12">
                  <c:v>PT10</c:v>
                </c:pt>
                <c:pt idx="13">
                  <c:v>PT11</c:v>
                </c:pt>
                <c:pt idx="14">
                  <c:v>PT12</c:v>
                </c:pt>
                <c:pt idx="15">
                  <c:v>PT13</c:v>
                </c:pt>
                <c:pt idx="16">
                  <c:v>PT14</c:v>
                </c:pt>
                <c:pt idx="17">
                  <c:v>PT15</c:v>
                </c:pt>
                <c:pt idx="18">
                  <c:v>PT16</c:v>
                </c:pt>
                <c:pt idx="19">
                  <c:v>PT17</c:v>
                </c:pt>
                <c:pt idx="20">
                  <c:v>PT18</c:v>
                </c:pt>
                <c:pt idx="21">
                  <c:v>PT19</c:v>
                </c:pt>
                <c:pt idx="22">
                  <c:v>PT20</c:v>
                </c:pt>
                <c:pt idx="23">
                  <c:v>PT21</c:v>
                </c:pt>
                <c:pt idx="24">
                  <c:v>PT22</c:v>
                </c:pt>
                <c:pt idx="25">
                  <c:v>PT23</c:v>
                </c:pt>
                <c:pt idx="26">
                  <c:v>PT24</c:v>
                </c:pt>
                <c:pt idx="27">
                  <c:v>PT25</c:v>
                </c:pt>
                <c:pt idx="28">
                  <c:v>PT26</c:v>
                </c:pt>
                <c:pt idx="29">
                  <c:v>PT27</c:v>
                </c:pt>
                <c:pt idx="30">
                  <c:v>PT28</c:v>
                </c:pt>
                <c:pt idx="31">
                  <c:v>PT29</c:v>
                </c:pt>
                <c:pt idx="32">
                  <c:v>PT30</c:v>
                </c:pt>
                <c:pt idx="33">
                  <c:v>PT31</c:v>
                </c:pt>
                <c:pt idx="34">
                  <c:v>PT32</c:v>
                </c:pt>
                <c:pt idx="35">
                  <c:v>PT33</c:v>
                </c:pt>
                <c:pt idx="36">
                  <c:v>PT34</c:v>
                </c:pt>
                <c:pt idx="37">
                  <c:v>PT36</c:v>
                </c:pt>
              </c:strCache>
            </c:strRef>
          </c:cat>
          <c:val>
            <c:numRef>
              <c:f>Sheet1!$I$123:$I$160</c:f>
              <c:numCache>
                <c:formatCode>General</c:formatCode>
                <c:ptCount val="38"/>
                <c:pt idx="0">
                  <c:v>0.35934863870087475</c:v>
                </c:pt>
                <c:pt idx="1">
                  <c:v>1.6265954207320661</c:v>
                </c:pt>
                <c:pt idx="2">
                  <c:v>0.25041318307413157</c:v>
                </c:pt>
                <c:pt idx="3">
                  <c:v>0.92841796329431059</c:v>
                </c:pt>
                <c:pt idx="4">
                  <c:v>0.99078125356101665</c:v>
                </c:pt>
                <c:pt idx="5">
                  <c:v>0.21965462286331822</c:v>
                </c:pt>
                <c:pt idx="6">
                  <c:v>0.47432685498544858</c:v>
                </c:pt>
                <c:pt idx="7">
                  <c:v>0.29430129377759023</c:v>
                </c:pt>
                <c:pt idx="8">
                  <c:v>1.562992045360863</c:v>
                </c:pt>
                <c:pt idx="9">
                  <c:v>1.4654872148029519</c:v>
                </c:pt>
                <c:pt idx="10">
                  <c:v>0.21995167546966801</c:v>
                </c:pt>
                <c:pt idx="11">
                  <c:v>0.24815022717352792</c:v>
                </c:pt>
                <c:pt idx="12">
                  <c:v>0.6152974684928969</c:v>
                </c:pt>
                <c:pt idx="13">
                  <c:v>0.75723275441160454</c:v>
                </c:pt>
                <c:pt idx="14">
                  <c:v>0.33209773598021575</c:v>
                </c:pt>
                <c:pt idx="15">
                  <c:v>1.1137632457584814</c:v>
                </c:pt>
                <c:pt idx="16">
                  <c:v>0.50007940244241722</c:v>
                </c:pt>
                <c:pt idx="17">
                  <c:v>1.2420639093992081</c:v>
                </c:pt>
                <c:pt idx="18">
                  <c:v>8.9419617978110433E-2</c:v>
                </c:pt>
                <c:pt idx="19">
                  <c:v>0.51252413017371767</c:v>
                </c:pt>
                <c:pt idx="20">
                  <c:v>0.7863871861760604</c:v>
                </c:pt>
                <c:pt idx="21">
                  <c:v>0.74405019282829465</c:v>
                </c:pt>
                <c:pt idx="22">
                  <c:v>0.31545629549794896</c:v>
                </c:pt>
                <c:pt idx="23">
                  <c:v>0.44073992218316543</c:v>
                </c:pt>
                <c:pt idx="24">
                  <c:v>0.57015822600999955</c:v>
                </c:pt>
                <c:pt idx="25">
                  <c:v>0.89962678493503467</c:v>
                </c:pt>
                <c:pt idx="26">
                  <c:v>3.0816115214848558</c:v>
                </c:pt>
                <c:pt idx="27">
                  <c:v>0.65767448112662164</c:v>
                </c:pt>
                <c:pt idx="28">
                  <c:v>2.0125074802629772</c:v>
                </c:pt>
                <c:pt idx="29">
                  <c:v>1.0559523218507527</c:v>
                </c:pt>
                <c:pt idx="30">
                  <c:v>0.61842245281511365</c:v>
                </c:pt>
                <c:pt idx="31">
                  <c:v>0.72735188798488648</c:v>
                </c:pt>
                <c:pt idx="32">
                  <c:v>0.64175301423883901</c:v>
                </c:pt>
                <c:pt idx="33">
                  <c:v>0.61791309563960772</c:v>
                </c:pt>
                <c:pt idx="34">
                  <c:v>0.49268220384014388</c:v>
                </c:pt>
                <c:pt idx="35">
                  <c:v>2.5765801581846715</c:v>
                </c:pt>
                <c:pt idx="36">
                  <c:v>1.221293458893183</c:v>
                </c:pt>
                <c:pt idx="37">
                  <c:v>0.218499191062928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6A1-46B5-8509-C08A7D715B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5067648"/>
        <c:axId val="193817408"/>
      </c:barChart>
      <c:catAx>
        <c:axId val="215067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txPr>
          <a:bodyPr rot="-2700000" vert="horz"/>
          <a:lstStyle/>
          <a:p>
            <a:pPr>
              <a:defRPr sz="8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93817408"/>
        <c:crosses val="autoZero"/>
        <c:auto val="1"/>
        <c:lblAlgn val="ctr"/>
        <c:lblOffset val="100"/>
        <c:tickLblSkip val="2"/>
        <c:tickMarkSkip val="1"/>
        <c:noMultiLvlLbl val="0"/>
      </c:catAx>
      <c:valAx>
        <c:axId val="193817408"/>
        <c:scaling>
          <c:orientation val="minMax"/>
          <c:max val="3.5939999999999999"/>
          <c:min val="0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 w="317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5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215067648"/>
        <c:crosses val="autoZero"/>
        <c:crossBetween val="between"/>
        <c:majorUnit val="0.35940000000000188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950" b="0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72DA-4E7A-9A73-1F612DF19D58}"/>
              </c:ext>
            </c:extLst>
          </c:dPt>
          <c:dPt>
            <c:idx val="3"/>
            <c:invertIfNegative val="0"/>
            <c:bubble3D val="0"/>
            <c:spPr>
              <a:solidFill>
                <a:prstClr val="black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72DA-4E7A-9A73-1F612DF19D58}"/>
              </c:ext>
            </c:extLst>
          </c:dPt>
          <c:dPt>
            <c:idx val="5"/>
            <c:invertIfNegative val="0"/>
            <c:bubble3D val="0"/>
            <c:spPr>
              <a:solidFill>
                <a:prstClr val="black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72DA-4E7A-9A73-1F612DF19D58}"/>
              </c:ext>
            </c:extLst>
          </c:dPt>
          <c:dPt>
            <c:idx val="7"/>
            <c:invertIfNegative val="0"/>
            <c:bubble3D val="0"/>
            <c:spPr>
              <a:solidFill>
                <a:prstClr val="black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72DA-4E7A-9A73-1F612DF19D58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M$19:$M$26</c:f>
                <c:numCache>
                  <c:formatCode>General</c:formatCode>
                  <c:ptCount val="8"/>
                  <c:pt idx="0">
                    <c:v>4.1017244397414422E-4</c:v>
                  </c:pt>
                  <c:pt idx="1">
                    <c:v>1.7592089699662437E-2</c:v>
                  </c:pt>
                  <c:pt idx="2">
                    <c:v>2.8927999173468888E-2</c:v>
                  </c:pt>
                  <c:pt idx="3">
                    <c:v>6.6424641075122984E-2</c:v>
                  </c:pt>
                  <c:pt idx="4">
                    <c:v>5.5654569055513983E-2</c:v>
                  </c:pt>
                  <c:pt idx="5">
                    <c:v>8.4100001172748226E-3</c:v>
                  </c:pt>
                  <c:pt idx="6">
                    <c:v>5.5424338775454246E-2</c:v>
                  </c:pt>
                  <c:pt idx="7">
                    <c:v>3.296147221071724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L$19:$L$26</c:f>
              <c:numCache>
                <c:formatCode>General</c:formatCode>
                <c:ptCount val="8"/>
                <c:pt idx="0">
                  <c:v>7.3240851974273213E-2</c:v>
                </c:pt>
                <c:pt idx="1">
                  <c:v>0.34565775271919175</c:v>
                </c:pt>
                <c:pt idx="2">
                  <c:v>0.59087396142675286</c:v>
                </c:pt>
                <c:pt idx="3">
                  <c:v>0.83107413434873589</c:v>
                </c:pt>
                <c:pt idx="4">
                  <c:v>0.56314879401807882</c:v>
                </c:pt>
                <c:pt idx="5">
                  <c:v>0.91236329195207455</c:v>
                </c:pt>
                <c:pt idx="6">
                  <c:v>0.49933246325850883</c:v>
                </c:pt>
                <c:pt idx="7">
                  <c:v>0.751529392972681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2DA-4E7A-9A73-1F612DF19D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7212416"/>
        <c:axId val="215404480"/>
      </c:barChart>
      <c:catAx>
        <c:axId val="21721241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solidFill>
              <a:schemeClr val="tx1"/>
            </a:solidFill>
          </a:ln>
        </c:spPr>
        <c:crossAx val="215404480"/>
        <c:crosses val="autoZero"/>
        <c:auto val="1"/>
        <c:lblAlgn val="ctr"/>
        <c:lblOffset val="100"/>
        <c:noMultiLvlLbl val="0"/>
      </c:catAx>
      <c:valAx>
        <c:axId val="215404480"/>
        <c:scaling>
          <c:orientation val="minMax"/>
          <c:max val="1.2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17212416"/>
        <c:crosses val="autoZero"/>
        <c:crossBetween val="between"/>
        <c:majorUnit val="0.2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noFill/>
            <a:ln>
              <a:solidFill>
                <a:sysClr val="windowText" lastClr="000000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8BD-44A6-90A4-93B4A111102A}"/>
              </c:ext>
            </c:extLst>
          </c:dPt>
          <c:dPt>
            <c:idx val="3"/>
            <c:invertIfNegative val="0"/>
            <c:bubble3D val="0"/>
            <c:spPr>
              <a:solidFill>
                <a:prstClr val="black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8BD-44A6-90A4-93B4A111102A}"/>
              </c:ext>
            </c:extLst>
          </c:dPt>
          <c:dPt>
            <c:idx val="5"/>
            <c:invertIfNegative val="0"/>
            <c:bubble3D val="0"/>
            <c:spPr>
              <a:solidFill>
                <a:prstClr val="black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A8BD-44A6-90A4-93B4A111102A}"/>
              </c:ext>
            </c:extLst>
          </c:dPt>
          <c:dPt>
            <c:idx val="7"/>
            <c:invertIfNegative val="0"/>
            <c:bubble3D val="0"/>
            <c:spPr>
              <a:solidFill>
                <a:prstClr val="black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A8BD-44A6-90A4-93B4A111102A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M$3:$M$10</c:f>
                <c:numCache>
                  <c:formatCode>General</c:formatCode>
                  <c:ptCount val="8"/>
                  <c:pt idx="0">
                    <c:v>1.9554140443542381E-2</c:v>
                  </c:pt>
                  <c:pt idx="1">
                    <c:v>9.5476174849133011E-2</c:v>
                  </c:pt>
                  <c:pt idx="2">
                    <c:v>0.25721521234731076</c:v>
                  </c:pt>
                  <c:pt idx="3">
                    <c:v>0.29181441381832601</c:v>
                  </c:pt>
                  <c:pt idx="4">
                    <c:v>0.14857248769946696</c:v>
                  </c:pt>
                  <c:pt idx="5">
                    <c:v>0.23904492448036202</c:v>
                  </c:pt>
                  <c:pt idx="6">
                    <c:v>2.4607453178725411E-2</c:v>
                  </c:pt>
                  <c:pt idx="7">
                    <c:v>0.19785820442185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L$3:$L$10</c:f>
              <c:numCache>
                <c:formatCode>General</c:formatCode>
                <c:ptCount val="8"/>
                <c:pt idx="0">
                  <c:v>0.4196206602479815</c:v>
                </c:pt>
                <c:pt idx="1">
                  <c:v>0.60744514986395526</c:v>
                </c:pt>
                <c:pt idx="2">
                  <c:v>1.4948717747992384</c:v>
                </c:pt>
                <c:pt idx="3">
                  <c:v>1.4393407025632348</c:v>
                </c:pt>
                <c:pt idx="4">
                  <c:v>1.8994950515275228</c:v>
                </c:pt>
                <c:pt idx="5">
                  <c:v>1.3659069277797904</c:v>
                </c:pt>
                <c:pt idx="6">
                  <c:v>1.605299070688214</c:v>
                </c:pt>
                <c:pt idx="7">
                  <c:v>1.40646376292608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8BD-44A6-90A4-93B4A11110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7212928"/>
        <c:axId val="215406784"/>
      </c:barChart>
      <c:catAx>
        <c:axId val="217212928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solidFill>
              <a:schemeClr val="tx1"/>
            </a:solidFill>
          </a:ln>
        </c:spPr>
        <c:crossAx val="215406784"/>
        <c:crosses val="autoZero"/>
        <c:auto val="1"/>
        <c:lblAlgn val="ctr"/>
        <c:lblOffset val="100"/>
        <c:noMultiLvlLbl val="0"/>
      </c:catAx>
      <c:valAx>
        <c:axId val="215406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1721292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959943611289274"/>
          <c:y val="8.8888888888889767E-2"/>
          <c:w val="0.68637452120605058"/>
          <c:h val="0.74949494949494955"/>
        </c:manualLayout>
      </c:layout>
      <c:barChart>
        <c:barDir val="col"/>
        <c:grouping val="clustered"/>
        <c:varyColors val="0"/>
        <c:ser>
          <c:idx val="1"/>
          <c:order val="1"/>
          <c:tx>
            <c:v>pbp</c:v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modify!$F$21,modify!$F$23)</c:f>
                <c:numCache>
                  <c:formatCode>General</c:formatCode>
                  <c:ptCount val="2"/>
                  <c:pt idx="0">
                    <c:v>2.720994557250337E-3</c:v>
                  </c:pt>
                  <c:pt idx="1">
                    <c:v>2.8382756858780906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multiLvlStrRef>
              <c:f>modify!$A$15:$B$18</c:f>
              <c:multiLvlStrCache>
                <c:ptCount val="4"/>
                <c:lvl>
                  <c:pt idx="0">
                    <c:v>pbp</c:v>
                  </c:pt>
                  <c:pt idx="1">
                    <c:v>CFD</c:v>
                  </c:pt>
                  <c:pt idx="2">
                    <c:v>pbp</c:v>
                  </c:pt>
                  <c:pt idx="3">
                    <c:v>CFD</c:v>
                  </c:pt>
                </c:lvl>
                <c:lvl>
                  <c:pt idx="0">
                    <c:v>0day</c:v>
                  </c:pt>
                  <c:pt idx="2">
                    <c:v>8day</c:v>
                  </c:pt>
                </c:lvl>
              </c:multiLvlStrCache>
            </c:multiLvlStrRef>
          </c:cat>
          <c:val>
            <c:numRef>
              <c:f>(modify!$D$21,modify!$D$23)</c:f>
              <c:numCache>
                <c:formatCode>General</c:formatCode>
                <c:ptCount val="2"/>
                <c:pt idx="0">
                  <c:v>5.6123505978656799E-2</c:v>
                </c:pt>
                <c:pt idx="1">
                  <c:v>8.189565302406179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D1-40B3-9E07-60523CA4AD78}"/>
            </c:ext>
          </c:extLst>
        </c:ser>
        <c:ser>
          <c:idx val="0"/>
          <c:order val="0"/>
          <c:tx>
            <c:v>CFD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modify!$F$22,modify!$F$24)</c:f>
                <c:numCache>
                  <c:formatCode>General</c:formatCode>
                  <c:ptCount val="2"/>
                  <c:pt idx="0">
                    <c:v>4.1529930971266338E-2</c:v>
                  </c:pt>
                  <c:pt idx="1">
                    <c:v>2.108393490602507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multiLvlStrRef>
              <c:f>modify!$A$15:$B$18</c:f>
              <c:multiLvlStrCache>
                <c:ptCount val="4"/>
                <c:lvl>
                  <c:pt idx="0">
                    <c:v>pbp</c:v>
                  </c:pt>
                  <c:pt idx="1">
                    <c:v>CFD</c:v>
                  </c:pt>
                  <c:pt idx="2">
                    <c:v>pbp</c:v>
                  </c:pt>
                  <c:pt idx="3">
                    <c:v>CFD</c:v>
                  </c:pt>
                </c:lvl>
                <c:lvl>
                  <c:pt idx="0">
                    <c:v>0day</c:v>
                  </c:pt>
                  <c:pt idx="2">
                    <c:v>8day</c:v>
                  </c:pt>
                </c:lvl>
              </c:multiLvlStrCache>
            </c:multiLvlStrRef>
          </c:cat>
          <c:val>
            <c:numRef>
              <c:f>(modify!$D$22,modify!$D$24)</c:f>
              <c:numCache>
                <c:formatCode>General</c:formatCode>
                <c:ptCount val="2"/>
                <c:pt idx="0">
                  <c:v>1.7121936979324195</c:v>
                </c:pt>
                <c:pt idx="1">
                  <c:v>2.02791895958005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D1-40B3-9E07-60523CA4AD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5162368"/>
        <c:axId val="193821440"/>
      </c:barChart>
      <c:catAx>
        <c:axId val="2151623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93821440"/>
        <c:crosses val="autoZero"/>
        <c:auto val="1"/>
        <c:lblAlgn val="ctr"/>
        <c:lblOffset val="100"/>
        <c:noMultiLvlLbl val="1"/>
      </c:catAx>
      <c:valAx>
        <c:axId val="193821440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215162368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959943611289274"/>
          <c:y val="8.8888888888889767E-2"/>
          <c:w val="0.68637452120605058"/>
          <c:h val="0.74949494949494955"/>
        </c:manualLayout>
      </c:layout>
      <c:barChart>
        <c:barDir val="col"/>
        <c:grouping val="clustered"/>
        <c:varyColors val="0"/>
        <c:ser>
          <c:idx val="1"/>
          <c:order val="1"/>
          <c:tx>
            <c:v>pbp</c:v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modify!$F$15,modify!$F$17)</c:f>
                <c:numCache>
                  <c:formatCode>General</c:formatCode>
                  <c:ptCount val="2"/>
                  <c:pt idx="0">
                    <c:v>3.8574057085343657E-3</c:v>
                  </c:pt>
                  <c:pt idx="1">
                    <c:v>1.678325772631192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odify!$A$15:$B$18</c:f>
              <c:multiLvlStrCache>
                <c:ptCount val="4"/>
                <c:lvl>
                  <c:pt idx="0">
                    <c:v>pbp</c:v>
                  </c:pt>
                  <c:pt idx="1">
                    <c:v>CFD</c:v>
                  </c:pt>
                  <c:pt idx="2">
                    <c:v>pbp</c:v>
                  </c:pt>
                  <c:pt idx="3">
                    <c:v>CFD</c:v>
                  </c:pt>
                </c:lvl>
                <c:lvl>
                  <c:pt idx="0">
                    <c:v>0day</c:v>
                  </c:pt>
                  <c:pt idx="2">
                    <c:v>8day</c:v>
                  </c:pt>
                </c:lvl>
              </c:multiLvlStrCache>
            </c:multiLvlStrRef>
          </c:cat>
          <c:val>
            <c:numRef>
              <c:f>(modify!$D$15,modify!$D$17)</c:f>
              <c:numCache>
                <c:formatCode>0.0000</c:formatCode>
                <c:ptCount val="2"/>
                <c:pt idx="0">
                  <c:v>0.10123192466097262</c:v>
                </c:pt>
                <c:pt idx="1">
                  <c:v>0.372761599904288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79F-4F38-B059-20EA0DF0A73F}"/>
            </c:ext>
          </c:extLst>
        </c:ser>
        <c:ser>
          <c:idx val="0"/>
          <c:order val="0"/>
          <c:tx>
            <c:v>CFD</c:v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modify!$F$16,modify!$F$18)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4.425031098303692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modify!$A$15:$B$18</c:f>
              <c:multiLvlStrCache>
                <c:ptCount val="4"/>
                <c:lvl>
                  <c:pt idx="0">
                    <c:v>pbp</c:v>
                  </c:pt>
                  <c:pt idx="1">
                    <c:v>CFD</c:v>
                  </c:pt>
                  <c:pt idx="2">
                    <c:v>pbp</c:v>
                  </c:pt>
                  <c:pt idx="3">
                    <c:v>CFD</c:v>
                  </c:pt>
                </c:lvl>
                <c:lvl>
                  <c:pt idx="0">
                    <c:v>0day</c:v>
                  </c:pt>
                  <c:pt idx="2">
                    <c:v>8day</c:v>
                  </c:pt>
                </c:lvl>
              </c:multiLvlStrCache>
            </c:multiLvlStrRef>
          </c:cat>
          <c:val>
            <c:numRef>
              <c:f>(modify!$D$16,modify!$D$18)</c:f>
              <c:numCache>
                <c:formatCode>0.0000</c:formatCode>
                <c:ptCount val="2"/>
                <c:pt idx="0">
                  <c:v>0.11971912337053672</c:v>
                </c:pt>
                <c:pt idx="1">
                  <c:v>0.672967885111284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79F-4F38-B059-20EA0DF0A7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5179264"/>
        <c:axId val="193823296"/>
      </c:barChart>
      <c:catAx>
        <c:axId val="2151792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93823296"/>
        <c:crosses val="autoZero"/>
        <c:auto val="1"/>
        <c:lblAlgn val="ctr"/>
        <c:lblOffset val="100"/>
        <c:noMultiLvlLbl val="1"/>
      </c:catAx>
      <c:valAx>
        <c:axId val="193823296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0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215179264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500-4320-B264-726C218F0B4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1500-4320-B264-726C218F0B4A}"/>
              </c:ext>
            </c:extLst>
          </c:dPt>
          <c:errBars>
            <c:errBarType val="plus"/>
            <c:errValType val="cust"/>
            <c:noEndCap val="0"/>
            <c:plus>
              <c:numRef>
                <c:f>'Plate 1 - Sheet1'!$G$32:$G$34</c:f>
                <c:numCache>
                  <c:formatCode>General</c:formatCode>
                  <c:ptCount val="3"/>
                  <c:pt idx="0">
                    <c:v>7.5999999999999984E-2</c:v>
                  </c:pt>
                  <c:pt idx="1">
                    <c:v>5.8000000000000072E-2</c:v>
                  </c:pt>
                  <c:pt idx="2">
                    <c:v>7.500000000000001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'Plate 1 - Sheet1'!$E$36:$E$38</c:f>
              <c:numCache>
                <c:formatCode>General</c:formatCode>
                <c:ptCount val="3"/>
                <c:pt idx="0">
                  <c:v>1</c:v>
                </c:pt>
                <c:pt idx="1">
                  <c:v>0.68002544529262077</c:v>
                </c:pt>
                <c:pt idx="2">
                  <c:v>0.692748091603054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500-4320-B264-726C218F0B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6674816"/>
        <c:axId val="193826752"/>
      </c:barChart>
      <c:catAx>
        <c:axId val="216674816"/>
        <c:scaling>
          <c:orientation val="minMax"/>
        </c:scaling>
        <c:delete val="0"/>
        <c:axPos val="b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193826752"/>
        <c:crosses val="autoZero"/>
        <c:auto val="1"/>
        <c:lblAlgn val="ctr"/>
        <c:lblOffset val="100"/>
        <c:noMultiLvlLbl val="0"/>
      </c:catAx>
      <c:valAx>
        <c:axId val="193826752"/>
        <c:scaling>
          <c:orientation val="minMax"/>
          <c:max val="1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16674816"/>
        <c:crosses val="autoZero"/>
        <c:crossBetween val="between"/>
        <c:majorUnit val="0.5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5B60-465E-B058-057A844B663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5B60-465E-B058-057A844B663C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Z$6:$Z$9</c:f>
                <c:numCache>
                  <c:formatCode>General</c:formatCode>
                  <c:ptCount val="4"/>
                  <c:pt idx="0">
                    <c:v>9.9267610934327552E-2</c:v>
                  </c:pt>
                  <c:pt idx="1">
                    <c:v>7.1521279391057235E-2</c:v>
                  </c:pt>
                  <c:pt idx="2">
                    <c:v>0.30831847652961297</c:v>
                  </c:pt>
                  <c:pt idx="3">
                    <c:v>0.647769050911028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multiLvlStrRef>
              <c:f>Sheet1!$AB$19:$AC$22</c:f>
              <c:multiLvlStrCache>
                <c:ptCount val="4"/>
                <c:lvl>
                  <c:pt idx="0">
                    <c:v>0</c:v>
                  </c:pt>
                  <c:pt idx="1">
                    <c:v>1</c:v>
                  </c:pt>
                  <c:pt idx="2">
                    <c:v>0</c:v>
                  </c:pt>
                  <c:pt idx="3">
                    <c:v>1</c:v>
                  </c:pt>
                </c:lvl>
                <c:lvl>
                  <c:pt idx="0">
                    <c:v>pbp</c:v>
                  </c:pt>
                  <c:pt idx="2">
                    <c:v>cfd</c:v>
                  </c:pt>
                </c:lvl>
              </c:multiLvlStrCache>
            </c:multiLvlStrRef>
          </c:cat>
          <c:val>
            <c:numRef>
              <c:f>Sheet1!$AB$6:$AB$9</c:f>
              <c:numCache>
                <c:formatCode>General</c:formatCode>
                <c:ptCount val="4"/>
                <c:pt idx="0">
                  <c:v>1</c:v>
                </c:pt>
                <c:pt idx="1">
                  <c:v>1.6542871667452179</c:v>
                </c:pt>
                <c:pt idx="2">
                  <c:v>3.757290913530384</c:v>
                </c:pt>
                <c:pt idx="3">
                  <c:v>4.69945468069243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5B60-465E-B058-057A844B663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6758784"/>
        <c:axId val="193829632"/>
      </c:barChart>
      <c:catAx>
        <c:axId val="2167587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93829632"/>
        <c:crosses val="autoZero"/>
        <c:auto val="1"/>
        <c:lblAlgn val="ctr"/>
        <c:lblOffset val="100"/>
        <c:noMultiLvlLbl val="1"/>
      </c:catAx>
      <c:valAx>
        <c:axId val="193829632"/>
        <c:scaling>
          <c:orientation val="minMax"/>
          <c:max val="8"/>
          <c:min val="0"/>
        </c:scaling>
        <c:delete val="0"/>
        <c:axPos val="l"/>
        <c:numFmt formatCode="0.00_ 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16758784"/>
        <c:crosses val="autoZero"/>
        <c:crossBetween val="between"/>
        <c:majorUnit val="4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A04A-41EE-A27B-9426E54FD2C5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A04A-41EE-A27B-9426E54FD2C5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Z$6:$Z$9</c:f>
                <c:numCache>
                  <c:formatCode>General</c:formatCode>
                  <c:ptCount val="4"/>
                  <c:pt idx="0">
                    <c:v>9.9267610934327552E-2</c:v>
                  </c:pt>
                  <c:pt idx="1">
                    <c:v>7.1521279391057235E-2</c:v>
                  </c:pt>
                  <c:pt idx="2">
                    <c:v>0.30831847652961297</c:v>
                  </c:pt>
                  <c:pt idx="3">
                    <c:v>0.647769050911028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multiLvlStrRef>
              <c:f>Sheet1!$AB$19:$AC$22</c:f>
              <c:multiLvlStrCache>
                <c:ptCount val="4"/>
                <c:lvl>
                  <c:pt idx="0">
                    <c:v>0</c:v>
                  </c:pt>
                  <c:pt idx="1">
                    <c:v>1</c:v>
                  </c:pt>
                  <c:pt idx="2">
                    <c:v>0</c:v>
                  </c:pt>
                  <c:pt idx="3">
                    <c:v>1</c:v>
                  </c:pt>
                </c:lvl>
                <c:lvl>
                  <c:pt idx="0">
                    <c:v>pbp</c:v>
                  </c:pt>
                  <c:pt idx="2">
                    <c:v>cfd</c:v>
                  </c:pt>
                </c:lvl>
              </c:multiLvlStrCache>
            </c:multiLvlStrRef>
          </c:cat>
          <c:val>
            <c:numRef>
              <c:f>Sheet1!$AB$10:$AB$13</c:f>
              <c:numCache>
                <c:formatCode>General</c:formatCode>
                <c:ptCount val="4"/>
                <c:pt idx="0">
                  <c:v>1</c:v>
                </c:pt>
                <c:pt idx="1">
                  <c:v>1.9473641560363415</c:v>
                </c:pt>
                <c:pt idx="2">
                  <c:v>2.2429425798154221</c:v>
                </c:pt>
                <c:pt idx="3">
                  <c:v>2.45544715288455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04A-41EE-A27B-9426E54FD2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6759296"/>
        <c:axId val="214942272"/>
      </c:barChart>
      <c:catAx>
        <c:axId val="2167592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14942272"/>
        <c:crosses val="autoZero"/>
        <c:auto val="1"/>
        <c:lblAlgn val="ctr"/>
        <c:lblOffset val="100"/>
        <c:noMultiLvlLbl val="1"/>
      </c:catAx>
      <c:valAx>
        <c:axId val="214942272"/>
        <c:scaling>
          <c:orientation val="minMax"/>
          <c:max val="4"/>
          <c:min val="0"/>
        </c:scaling>
        <c:delete val="0"/>
        <c:axPos val="l"/>
        <c:numFmt formatCode="0.00_ 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16759296"/>
        <c:crosses val="autoZero"/>
        <c:crossBetween val="between"/>
        <c:majorUnit val="2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6B5-4E91-8DB1-AA2835E709BC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6B5-4E91-8DB1-AA2835E709BC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Z$6:$Z$9</c:f>
                <c:numCache>
                  <c:formatCode>General</c:formatCode>
                  <c:ptCount val="4"/>
                  <c:pt idx="0">
                    <c:v>9.9267610934327552E-2</c:v>
                  </c:pt>
                  <c:pt idx="1">
                    <c:v>7.1521279391057235E-2</c:v>
                  </c:pt>
                  <c:pt idx="2">
                    <c:v>0.30831847652961297</c:v>
                  </c:pt>
                  <c:pt idx="3">
                    <c:v>0.647769050911028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multiLvlStrRef>
              <c:f>Sheet1!$AB$19:$AC$22</c:f>
              <c:multiLvlStrCache>
                <c:ptCount val="4"/>
                <c:lvl>
                  <c:pt idx="0">
                    <c:v>0</c:v>
                  </c:pt>
                  <c:pt idx="1">
                    <c:v>1</c:v>
                  </c:pt>
                  <c:pt idx="2">
                    <c:v>0</c:v>
                  </c:pt>
                  <c:pt idx="3">
                    <c:v>1</c:v>
                  </c:pt>
                </c:lvl>
                <c:lvl>
                  <c:pt idx="0">
                    <c:v>pbp</c:v>
                  </c:pt>
                  <c:pt idx="2">
                    <c:v>cfd</c:v>
                  </c:pt>
                </c:lvl>
              </c:multiLvlStrCache>
            </c:multiLvlStrRef>
          </c:cat>
          <c:val>
            <c:numRef>
              <c:f>Sheet1!$AB$14:$AB$17</c:f>
              <c:numCache>
                <c:formatCode>General</c:formatCode>
                <c:ptCount val="4"/>
                <c:pt idx="0">
                  <c:v>1</c:v>
                </c:pt>
                <c:pt idx="1">
                  <c:v>1.7841034347475093</c:v>
                </c:pt>
                <c:pt idx="2">
                  <c:v>4.8566628671974685</c:v>
                </c:pt>
                <c:pt idx="3">
                  <c:v>3.82774201221885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6B5-4E91-8DB1-AA2835E709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6836096"/>
        <c:axId val="214948032"/>
      </c:barChart>
      <c:catAx>
        <c:axId val="2168360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14948032"/>
        <c:crosses val="autoZero"/>
        <c:auto val="1"/>
        <c:lblAlgn val="ctr"/>
        <c:lblOffset val="100"/>
        <c:noMultiLvlLbl val="1"/>
      </c:catAx>
      <c:valAx>
        <c:axId val="214948032"/>
        <c:scaling>
          <c:orientation val="minMax"/>
          <c:max val="8"/>
          <c:min val="0"/>
        </c:scaling>
        <c:delete val="0"/>
        <c:axPos val="l"/>
        <c:numFmt formatCode="0.00_ 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16836096"/>
        <c:crosses val="autoZero"/>
        <c:crossBetween val="between"/>
        <c:majorUnit val="4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B67-49F7-8BF8-1B058CAFA41B}"/>
              </c:ext>
            </c:extLst>
          </c:dPt>
          <c:dPt>
            <c:idx val="1"/>
            <c:invertIfNegative val="0"/>
            <c:bubble3D val="0"/>
            <c:spPr>
              <a:solidFill>
                <a:prstClr val="white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9B67-49F7-8BF8-1B058CAFA41B}"/>
              </c:ext>
            </c:extLst>
          </c:dPt>
          <c:errBars>
            <c:errBarType val="plus"/>
            <c:errValType val="cust"/>
            <c:noEndCap val="0"/>
            <c:plus>
              <c:numRef>
                <c:f>'Plate 1 - Sheet1'!$G$57:$J$57</c:f>
                <c:numCache>
                  <c:formatCode>General</c:formatCode>
                  <c:ptCount val="4"/>
                  <c:pt idx="0">
                    <c:v>2.4999999999999911E-2</c:v>
                  </c:pt>
                  <c:pt idx="1">
                    <c:v>1.1250000000000105E-2</c:v>
                  </c:pt>
                  <c:pt idx="2">
                    <c:v>1.0000000000000021E-2</c:v>
                  </c:pt>
                  <c:pt idx="3">
                    <c:v>7.374999999999998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multiLvlStrRef>
              <c:f>'Plate 1 - Sheet1'!$C$51:$F$52</c:f>
              <c:multiLvlStrCache>
                <c:ptCount val="4"/>
                <c:lvl>
                  <c:pt idx="0">
                    <c:v>0</c:v>
                  </c:pt>
                  <c:pt idx="1">
                    <c:v>1</c:v>
                  </c:pt>
                  <c:pt idx="2">
                    <c:v>0</c:v>
                  </c:pt>
                  <c:pt idx="3">
                    <c:v>1</c:v>
                  </c:pt>
                </c:lvl>
                <c:lvl>
                  <c:pt idx="0">
                    <c:v>pbp</c:v>
                  </c:pt>
                  <c:pt idx="2">
                    <c:v>cfd</c:v>
                  </c:pt>
                </c:lvl>
              </c:multiLvlStrCache>
            </c:multiLvlStrRef>
          </c:cat>
          <c:val>
            <c:numRef>
              <c:f>'Plate 1 - Sheet1'!$G$55:$J$55</c:f>
              <c:numCache>
                <c:formatCode>General</c:formatCode>
                <c:ptCount val="4"/>
                <c:pt idx="0">
                  <c:v>1.0249999999999941</c:v>
                </c:pt>
                <c:pt idx="1">
                  <c:v>1.3387500000000001</c:v>
                </c:pt>
                <c:pt idx="2">
                  <c:v>1.8399999999999932</c:v>
                </c:pt>
                <c:pt idx="3">
                  <c:v>1.88874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B67-49F7-8BF8-1B058CAFA4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6837632"/>
        <c:axId val="215401600"/>
      </c:barChart>
      <c:catAx>
        <c:axId val="21683763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215401600"/>
        <c:crosses val="autoZero"/>
        <c:auto val="1"/>
        <c:lblAlgn val="ctr"/>
        <c:lblOffset val="100"/>
        <c:noMultiLvlLbl val="1"/>
      </c:catAx>
      <c:valAx>
        <c:axId val="215401600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216837632"/>
        <c:crosses val="autoZero"/>
        <c:crossBetween val="between"/>
        <c:majorUnit val="1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622-4D32-BEC3-80D467DEF34A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622-4D32-BEC3-80D467DEF34A}"/>
              </c:ext>
            </c:extLst>
          </c:dPt>
          <c:errBars>
            <c:errBarType val="plus"/>
            <c:errValType val="cust"/>
            <c:noEndCap val="0"/>
            <c:plus>
              <c:numRef>
                <c:f>'Plate 1 - Sheet1'!$J$36:$L$36</c:f>
                <c:numCache>
                  <c:formatCode>General</c:formatCode>
                  <c:ptCount val="3"/>
                  <c:pt idx="0">
                    <c:v>1.1000000000000058E-2</c:v>
                  </c:pt>
                  <c:pt idx="1">
                    <c:v>1.0500000000000021E-2</c:v>
                  </c:pt>
                  <c:pt idx="2">
                    <c:v>5.0000000000000131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'Plate 1 - Sheet1'!$J$31:$L$31</c:f>
              <c:strCache>
                <c:ptCount val="3"/>
                <c:pt idx="0">
                  <c:v>Scr</c:v>
                </c:pt>
                <c:pt idx="1">
                  <c:v>#1</c:v>
                </c:pt>
                <c:pt idx="2">
                  <c:v>#2</c:v>
                </c:pt>
              </c:strCache>
            </c:strRef>
          </c:cat>
          <c:val>
            <c:numRef>
              <c:f>'Plate 1 - Sheet1'!$M$34:$O$34</c:f>
              <c:numCache>
                <c:formatCode>General</c:formatCode>
                <c:ptCount val="3"/>
                <c:pt idx="0">
                  <c:v>1.01413881748072</c:v>
                </c:pt>
                <c:pt idx="1">
                  <c:v>0.31683804627249468</c:v>
                </c:pt>
                <c:pt idx="2">
                  <c:v>0.442802056555269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622-4D32-BEC3-80D467DEF3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7125376"/>
        <c:axId val="215403904"/>
      </c:barChart>
      <c:catAx>
        <c:axId val="217125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215403904"/>
        <c:crosses val="autoZero"/>
        <c:auto val="1"/>
        <c:lblAlgn val="ctr"/>
        <c:lblOffset val="100"/>
        <c:noMultiLvlLbl val="0"/>
      </c:catAx>
      <c:valAx>
        <c:axId val="215403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/>
            </a:pPr>
            <a:endParaRPr lang="en-US"/>
          </a:p>
        </c:txPr>
        <c:crossAx val="217125376"/>
        <c:crosses val="autoZero"/>
        <c:crossBetween val="between"/>
        <c:majorUnit val="0.5"/>
      </c:valAx>
      <c:spPr>
        <a:ln>
          <a:noFill/>
        </a:ln>
      </c:spPr>
    </c:plotArea>
    <c:plotVisOnly val="1"/>
    <c:dispBlanksAs val="gap"/>
    <c:showDLblsOverMax val="0"/>
  </c:chart>
  <c:txPr>
    <a:bodyPr/>
    <a:lstStyle/>
    <a:p>
      <a:pPr>
        <a:defRPr sz="14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6667</cdr:x>
      <cdr:y>0.08274</cdr:y>
    </cdr:from>
    <cdr:to>
      <cdr:x>0.25755</cdr:x>
      <cdr:y>0.26442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44016" y="119148"/>
          <a:ext cx="412292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1100" b="0" i="1" dirty="0">
              <a:latin typeface="Times New Roman" panose="02020603050405020304" pitchFamily="18" charset="0"/>
              <a:cs typeface="Times New Roman" panose="02020603050405020304" pitchFamily="18" charset="0"/>
            </a:rPr>
            <a:t>aP2</a:t>
          </a:r>
          <a:endParaRPr lang="ko-KR" altLang="en-US" sz="1100" b="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644</cdr:x>
      <cdr:y>0.0734</cdr:y>
    </cdr:from>
    <cdr:to>
      <cdr:x>0.33988</cdr:x>
      <cdr:y>0.2550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9096" y="105701"/>
          <a:ext cx="595035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1100" b="0" i="1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C/</a:t>
          </a:r>
          <a:r>
            <a:rPr lang="en-US" altLang="ko-KR" sz="1100" b="0" i="1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ebp</a:t>
          </a:r>
          <a:r>
            <a:rPr lang="el-GR" altLang="ko-KR" sz="1100" b="0" i="1" dirty="0" smtClean="0">
              <a:latin typeface="Times New Roman" panose="02020603050405020304" pitchFamily="18" charset="0"/>
              <a:ea typeface="맑은 고딕"/>
              <a:cs typeface="Times New Roman" panose="02020603050405020304" pitchFamily="18" charset="0"/>
            </a:rPr>
            <a:t>α</a:t>
          </a:r>
          <a:endParaRPr lang="ko-KR" altLang="en-US" sz="1100" b="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6656</cdr:x>
      <cdr:y>0.08546</cdr:y>
    </cdr:from>
    <cdr:to>
      <cdr:x>0.31236</cdr:x>
      <cdr:y>0.26713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43774" y="123064"/>
          <a:ext cx="530915" cy="261610"/>
        </a:xfrm>
        <a:prstGeom xmlns:a="http://schemas.openxmlformats.org/drawingml/2006/main" prst="rect">
          <a:avLst/>
        </a:prstGeom>
        <a:noFill xmlns:a="http://schemas.openxmlformats.org/drawingml/2006/main"/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wrap="none" rtlCol="0" anchor="t">
          <a:spAutoFit/>
        </a:bodyPr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altLang="ko-KR" sz="1100" b="0" i="1" dirty="0">
              <a:latin typeface="Times New Roman" panose="02020603050405020304" pitchFamily="18" charset="0"/>
              <a:cs typeface="Times New Roman" panose="02020603050405020304" pitchFamily="18" charset="0"/>
            </a:rPr>
            <a:t>CD36</a:t>
          </a:r>
          <a:endParaRPr lang="ko-KR" altLang="en-US" sz="1100" b="0" i="1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18258</cdr:x>
      <cdr:y>0.14159</cdr:y>
    </cdr:from>
    <cdr:to>
      <cdr:x>0.45225</cdr:x>
      <cdr:y>0.566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19125" y="3048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ko-KR" altLang="en-US" sz="110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18258</cdr:x>
      <cdr:y>0.14159</cdr:y>
    </cdr:from>
    <cdr:to>
      <cdr:x>0.45225</cdr:x>
      <cdr:y>0.5663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19125" y="304800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ko-KR" altLang="en-US" sz="110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821294-5C70-4F42-8C3A-CFBCE852402D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709613" y="4860925"/>
            <a:ext cx="5680075" cy="4605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11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14E31E-5C44-425E-B6A4-B2E1DC41D66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32255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D6E8A-D5DF-4365-AFB9-9E7D62E4E058}" type="datetimeFigureOut">
              <a:rPr lang="ko-KR" altLang="en-US" smtClean="0"/>
              <a:pPr/>
              <a:t>2016-08-2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6A04E7-EB81-45D2-B93F-34593C2E278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kwpark@skku.edu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3568" y="-243408"/>
            <a:ext cx="7772400" cy="1470025"/>
          </a:xfrm>
        </p:spPr>
        <p:txBody>
          <a:bodyPr>
            <a:normAutofit/>
          </a:bodyPr>
          <a:lstStyle/>
          <a:p>
            <a:r>
              <a:rPr lang="en-US" altLang="ko-KR" sz="3200" dirty="0" smtClean="0">
                <a:latin typeface="Times New Roman" pitchFamily="18" charset="0"/>
                <a:cs typeface="Times New Roman" pitchFamily="18" charset="0"/>
              </a:rPr>
              <a:t>Supplementary Information</a:t>
            </a:r>
            <a:endParaRPr lang="ko-KR" altLang="en-US" sz="3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8" name="Rectangle 4"/>
          <p:cNvSpPr>
            <a:spLocks noChangeArrowheads="1"/>
          </p:cNvSpPr>
          <p:nvPr/>
        </p:nvSpPr>
        <p:spPr bwMode="auto">
          <a:xfrm>
            <a:off x="755576" y="1042283"/>
            <a:ext cx="7632848" cy="51398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altLang="ko-KR" sz="1600" b="1" dirty="0" smtClean="0">
                <a:latin typeface="Times New Roman" pitchFamily="18" charset="0"/>
                <a:cs typeface="Times New Roman" pitchFamily="18" charset="0"/>
              </a:rPr>
              <a:t>Small molecule-induced Complement Factor D (</a:t>
            </a:r>
            <a:r>
              <a:rPr lang="en-US" altLang="ko-KR" sz="1600" b="1" dirty="0" err="1" smtClean="0">
                <a:latin typeface="Times New Roman" pitchFamily="18" charset="0"/>
                <a:cs typeface="Times New Roman" pitchFamily="18" charset="0"/>
              </a:rPr>
              <a:t>adipsin</a:t>
            </a:r>
            <a:r>
              <a:rPr lang="en-US" altLang="ko-KR" sz="1600" b="1" dirty="0" smtClean="0">
                <a:latin typeface="Times New Roman" pitchFamily="18" charset="0"/>
                <a:cs typeface="Times New Roman" pitchFamily="18" charset="0"/>
              </a:rPr>
              <a:t>) promotes lipid accumulation and </a:t>
            </a:r>
            <a:r>
              <a:rPr lang="en-US" altLang="ko-KR" sz="1600" b="1" dirty="0" err="1" smtClean="0">
                <a:latin typeface="Times New Roman" pitchFamily="18" charset="0"/>
                <a:cs typeface="Times New Roman" pitchFamily="18" charset="0"/>
              </a:rPr>
              <a:t>adipocyte</a:t>
            </a:r>
            <a:r>
              <a:rPr lang="en-US" altLang="ko-KR" sz="1600" b="1" dirty="0" smtClean="0">
                <a:latin typeface="Times New Roman" pitchFamily="18" charset="0"/>
                <a:cs typeface="Times New Roman" pitchFamily="18" charset="0"/>
              </a:rPr>
              <a:t> differentiation. </a:t>
            </a:r>
            <a:endParaRPr lang="ko-KR" altLang="ko-KR" sz="1600" dirty="0" smtClean="0"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060700" algn="l"/>
              </a:tabLst>
            </a:pPr>
            <a:endParaRPr kumimoji="1" lang="en-US" altLang="ko-KR" sz="1200" b="0" i="0" u="none" strike="noStrike" cap="none" normalizeH="0" baseline="0" dirty="0" smtClean="0">
              <a:ln>
                <a:noFill/>
              </a:ln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latinLnBrk="0"/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No-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Joon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Song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1, #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uji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Kim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1,#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Byung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-Hyun Jang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eo-Hyuk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Chang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</a:t>
            </a:r>
            <a:r>
              <a:rPr lang="en-US" altLang="ko-KR" sz="1200" dirty="0"/>
              <a:t>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eon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un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Ki-Moon Park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Hironori Waki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an Y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Peter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Tontonoz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4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and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Ky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Won Park </a:t>
            </a:r>
            <a:r>
              <a:rPr lang="en-US" altLang="ko-KR" sz="1200" baseline="30000" dirty="0" smtClean="0">
                <a:latin typeface="Times New Roman" pitchFamily="18" charset="0"/>
                <a:cs typeface="Times New Roman" pitchFamily="18" charset="0"/>
              </a:rPr>
              <a:t>1,*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060700" algn="l"/>
              </a:tabLst>
            </a:pPr>
            <a:endParaRPr kumimoji="1" lang="en-US" altLang="ko-KR" sz="1200" b="0" i="0" u="none" strike="noStrike" cap="none" normalizeH="0" baseline="0" dirty="0" smtClean="0">
              <a:ln>
                <a:noFill/>
              </a:ln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latinLnBrk="0"/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Food Science and Biotechnology,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ngkyunkwan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iversity 16419, Korea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atinLnBrk="0"/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Diabetes and Metabolic Diseases, Graduate School of Medicine, University of Tokyo, Tokyo 113-8655, Japan. 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partment of Medicine, Program in Molecular Medicine, University of Utah, 15 North 2030 East, Salt Lake City, UT 84112, USA. </a:t>
            </a:r>
            <a:r>
              <a:rPr lang="en-US" sz="12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ward Hughes Medical Institute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Department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Pathology and Laboratory Medicine, University of California, Los Angeles, Los Angeles, CA 90095, USA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060700" algn="l"/>
              </a:tabLst>
            </a:pPr>
            <a:endParaRPr kumimoji="1" lang="en-US" altLang="ko-KR" sz="1200" b="0" i="0" u="none" strike="noStrike" cap="none" normalizeH="0" baseline="0" dirty="0" smtClean="0">
              <a:ln>
                <a:noFill/>
              </a:ln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algn="just"/>
            <a:r>
              <a:rPr lang="en-US" altLang="ko-KR" sz="1200" kern="100" dirty="0" smtClean="0">
                <a:latin typeface="Times New Roman"/>
                <a:cs typeface="Times New Roman"/>
              </a:rPr>
              <a:t> </a:t>
            </a:r>
            <a:endParaRPr lang="ko-KR" altLang="ko-KR" sz="1000" kern="100" dirty="0" smtClean="0">
              <a:cs typeface="Times New Roman"/>
            </a:endParaRPr>
          </a:p>
          <a:p>
            <a:pPr algn="just"/>
            <a:r>
              <a:rPr lang="en-US" altLang="ko-KR" sz="1200" kern="100" baseline="30000" dirty="0" smtClean="0">
                <a:latin typeface="Times New Roman"/>
                <a:cs typeface="Times New Roman"/>
              </a:rPr>
              <a:t>*</a:t>
            </a:r>
            <a:r>
              <a:rPr lang="en-US" altLang="ko-KR" sz="1200" kern="100" dirty="0" smtClean="0">
                <a:latin typeface="Times New Roman"/>
                <a:cs typeface="Times New Roman"/>
              </a:rPr>
              <a:t>Corresponding authors:</a:t>
            </a:r>
            <a:r>
              <a:rPr lang="en-US" altLang="ko-KR" sz="1000" kern="100" dirty="0" smtClean="0">
                <a:cs typeface="Times New Roman"/>
              </a:rPr>
              <a:t> </a:t>
            </a:r>
            <a:r>
              <a:rPr lang="en-US" altLang="ko-KR" sz="1200" kern="100" dirty="0" err="1" smtClean="0">
                <a:latin typeface="Times New Roman"/>
                <a:cs typeface="Times New Roman"/>
              </a:rPr>
              <a:t>Kye</a:t>
            </a:r>
            <a:r>
              <a:rPr lang="en-US" altLang="ko-KR" sz="1200" kern="100" dirty="0" smtClean="0">
                <a:latin typeface="Times New Roman"/>
                <a:cs typeface="Times New Roman"/>
              </a:rPr>
              <a:t> Won Park, PhD., </a:t>
            </a:r>
            <a:r>
              <a:rPr lang="en-US" altLang="ko-KR" sz="1200" kern="100" dirty="0" smtClean="0">
                <a:latin typeface="Times New Roman"/>
                <a:ea typeface="굴림"/>
                <a:cs typeface="Times New Roman"/>
              </a:rPr>
              <a:t>Department of Food Science and Biotechnology, </a:t>
            </a:r>
            <a:r>
              <a:rPr lang="en-US" altLang="ko-KR" sz="1200" kern="100" dirty="0" err="1" smtClean="0">
                <a:latin typeface="Times New Roman"/>
                <a:ea typeface="굴림"/>
                <a:cs typeface="Times New Roman"/>
              </a:rPr>
              <a:t>Sungkyunkwan</a:t>
            </a:r>
            <a:r>
              <a:rPr lang="en-US" altLang="ko-KR" sz="1200" kern="100" dirty="0" smtClean="0">
                <a:latin typeface="Times New Roman"/>
                <a:ea typeface="굴림"/>
                <a:cs typeface="Times New Roman"/>
              </a:rPr>
              <a:t> University,</a:t>
            </a:r>
            <a:r>
              <a:rPr lang="en-US" altLang="ko-KR" sz="1200" kern="100" dirty="0" smtClean="0">
                <a:latin typeface="Times New Roman"/>
                <a:cs typeface="Times New Roman"/>
              </a:rPr>
              <a:t> Suwon 440-746, Korea. Phone: +82-31-290-7804, </a:t>
            </a:r>
            <a:r>
              <a:rPr lang="es-ES" altLang="ko-KR" sz="1200" kern="100" dirty="0" smtClean="0">
                <a:latin typeface="Times New Roman"/>
                <a:cs typeface="Times New Roman"/>
              </a:rPr>
              <a:t>Fax: (+82) 31-290-7882, E-mail: </a:t>
            </a:r>
            <a:r>
              <a:rPr lang="en-US" altLang="ko-KR" sz="1200" u="sng" kern="100" dirty="0" smtClean="0">
                <a:latin typeface="Times New Roman"/>
                <a:cs typeface="Times New Roman"/>
                <a:hlinkClick r:id="rId2"/>
              </a:rPr>
              <a:t>kwpark@skku.edu</a:t>
            </a:r>
            <a:endParaRPr lang="ko-KR" altLang="ko-KR" sz="1000" kern="100" dirty="0" smtClean="0">
              <a:cs typeface="Times New Roman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060700" algn="l"/>
              </a:tabLst>
            </a:pPr>
            <a:endParaRPr kumimoji="1" lang="en-US" altLang="ko-KR" sz="2000" b="0" i="0" u="none" strike="noStrike" cap="none" normalizeH="0" baseline="0" dirty="0" smtClean="0">
              <a:ln>
                <a:noFill/>
              </a:ln>
              <a:effectLst/>
              <a:latin typeface="굴림" pitchFamily="50" charset="-127"/>
              <a:ea typeface="굴림" pitchFamily="50" charset="-127"/>
              <a:cs typeface="굴림" pitchFamily="50" charset="-127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3060700" algn="l"/>
              </a:tabLst>
            </a:pP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Information:</a:t>
            </a:r>
          </a:p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  <a:tabLst>
                <a:tab pos="3060700" algn="l"/>
              </a:tabLst>
            </a:pP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figure </a:t>
            </a: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A</a:t>
            </a: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: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Identification of small molecule regulators of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expression and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genesis</a:t>
            </a:r>
            <a:endParaRPr kumimoji="1" lang="en-US" altLang="ko-KR" sz="1200" dirty="0" smtClean="0"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  <a:tabLst>
                <a:tab pos="3060700" algn="l"/>
              </a:tabLst>
            </a:pP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figure </a:t>
            </a: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B</a:t>
            </a: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: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tructures of small molecules</a:t>
            </a:r>
            <a:endParaRPr kumimoji="1" lang="en-US" altLang="ko-KR" sz="1200" dirty="0" smtClean="0"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  <a:tabLst>
                <a:tab pos="3060700" algn="l"/>
              </a:tabLst>
            </a:pP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figure </a:t>
            </a: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C</a:t>
            </a: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table overexpression of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Cf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in C3H10T1/2 cells promotes lipid accumulation and adipocyte differentiation. </a:t>
            </a:r>
            <a:endParaRPr kumimoji="1" lang="en-US" altLang="ko-KR" sz="1200" dirty="0" smtClean="0"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  <a:tabLst>
                <a:tab pos="3060700" algn="l"/>
              </a:tabLst>
            </a:pP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figure </a:t>
            </a: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D</a:t>
            </a: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: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Knockdown of C3aR suppresses adipocyte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differentiation.</a:t>
            </a:r>
            <a:endParaRPr kumimoji="1" lang="en-US" altLang="ko-KR" sz="1200" dirty="0" smtClean="0"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  <a:tabLst>
                <a:tab pos="3060700" algn="l"/>
              </a:tabLst>
            </a:pP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figure </a:t>
            </a: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E</a:t>
            </a: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: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C3aR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activation bypasses the stimulatory actions of </a:t>
            </a:r>
            <a:r>
              <a:rPr lang="en-US" altLang="ko-KR" sz="1200" dirty="0" err="1">
                <a:latin typeface="Times New Roman" pitchFamily="18" charset="0"/>
                <a:cs typeface="Times New Roman" pitchFamily="18" charset="0"/>
              </a:rPr>
              <a:t>Cfd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in adipocyte differentiation</a:t>
            </a:r>
            <a:endParaRPr kumimoji="1" lang="en-US" altLang="ko-KR" sz="1200" dirty="0" smtClean="0"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  <a:p>
            <a:pPr eaLnBrk="0" fontAlgn="base" latinLnBrk="0" hangingPunct="0">
              <a:spcBef>
                <a:spcPct val="0"/>
              </a:spcBef>
              <a:spcAft>
                <a:spcPct val="0"/>
              </a:spcAft>
              <a:tabLst>
                <a:tab pos="3060700" algn="l"/>
              </a:tabLst>
            </a:pP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</a:t>
            </a:r>
            <a:r>
              <a:rPr kumimoji="1" lang="en-US" altLang="ko-KR" sz="1200" b="1" dirty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figure </a:t>
            </a:r>
            <a:r>
              <a:rPr kumimoji="1" lang="en-US" altLang="ko-KR" sz="1200" b="1" dirty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F</a:t>
            </a: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: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Silencing of Ccl9 suppresses adipocyte differentiation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</a:p>
          <a:p>
            <a:pPr eaLnBrk="0" fontAlgn="base" latinLnBrk="0" hangingPunct="0">
              <a:spcBef>
                <a:spcPct val="0"/>
              </a:spcBef>
              <a:spcAft>
                <a:spcPct val="0"/>
              </a:spcAft>
              <a:tabLst>
                <a:tab pos="3060700" algn="l"/>
              </a:tabLst>
            </a:pPr>
            <a:r>
              <a:rPr kumimoji="1" lang="en-US" altLang="ko-KR" sz="1200" b="1" dirty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Supplementary figure </a:t>
            </a:r>
            <a:r>
              <a:rPr kumimoji="1" lang="en-US" altLang="ko-KR" sz="1200" b="1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G</a:t>
            </a:r>
            <a:r>
              <a:rPr kumimoji="1" lang="en-US" altLang="ko-KR" sz="1200" dirty="0" smtClean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: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Combinatory effects of the selected small molecules and GW7845 on </a:t>
            </a:r>
            <a:r>
              <a:rPr lang="en-US" altLang="ko-KR" sz="1200" dirty="0" err="1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 and aP2 expression.</a:t>
            </a:r>
            <a:r>
              <a:rPr kumimoji="1" lang="en-US" altLang="ko-KR" sz="1200" b="1" dirty="0">
                <a:latin typeface="Times New Roman" pitchFamily="18" charset="0"/>
                <a:ea typeface="굴림" pitchFamily="50" charset="-127"/>
                <a:cs typeface="Times New Roman" pitchFamily="18" charset="0"/>
              </a:rPr>
              <a:t> </a:t>
            </a:r>
            <a:endParaRPr kumimoji="1" lang="en-US" altLang="ko-KR" sz="1200" b="1" dirty="0" smtClean="0"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44328791"/>
              </p:ext>
            </p:extLst>
          </p:nvPr>
        </p:nvGraphicFramePr>
        <p:xfrm>
          <a:off x="1479481" y="-253563"/>
          <a:ext cx="6587199" cy="2408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3" name="직선 연결선 2"/>
          <p:cNvCxnSpPr/>
          <p:nvPr/>
        </p:nvCxnSpPr>
        <p:spPr>
          <a:xfrm>
            <a:off x="1675922" y="1665581"/>
            <a:ext cx="6192000" cy="0"/>
          </a:xfrm>
          <a:prstGeom prst="line">
            <a:avLst/>
          </a:prstGeom>
          <a:ln w="12700">
            <a:solidFill>
              <a:srgbClr val="C0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직선 화살표 연결선 3"/>
          <p:cNvCxnSpPr/>
          <p:nvPr/>
        </p:nvCxnSpPr>
        <p:spPr>
          <a:xfrm>
            <a:off x="3066080" y="666944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직선 화살표 연결선 4"/>
          <p:cNvCxnSpPr/>
          <p:nvPr/>
        </p:nvCxnSpPr>
        <p:spPr>
          <a:xfrm>
            <a:off x="3197214" y="666944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직선 화살표 연결선 5"/>
          <p:cNvCxnSpPr/>
          <p:nvPr/>
        </p:nvCxnSpPr>
        <p:spPr>
          <a:xfrm>
            <a:off x="6014966" y="43044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직선 화살표 연결선 6"/>
          <p:cNvCxnSpPr/>
          <p:nvPr/>
        </p:nvCxnSpPr>
        <p:spPr>
          <a:xfrm>
            <a:off x="6358290" y="521532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직선 화살표 연결선 7"/>
          <p:cNvCxnSpPr/>
          <p:nvPr/>
        </p:nvCxnSpPr>
        <p:spPr>
          <a:xfrm>
            <a:off x="7510625" y="279655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직선 화살표 연결선 8"/>
          <p:cNvCxnSpPr/>
          <p:nvPr/>
        </p:nvCxnSpPr>
        <p:spPr>
          <a:xfrm>
            <a:off x="2211509" y="1069516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화살표 연결선 9"/>
          <p:cNvCxnSpPr/>
          <p:nvPr/>
        </p:nvCxnSpPr>
        <p:spPr>
          <a:xfrm>
            <a:off x="2363909" y="1037617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화살표 연결선 10"/>
          <p:cNvCxnSpPr/>
          <p:nvPr/>
        </p:nvCxnSpPr>
        <p:spPr>
          <a:xfrm>
            <a:off x="3872066" y="1176200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직선 화살표 연결선 11"/>
          <p:cNvCxnSpPr/>
          <p:nvPr/>
        </p:nvCxnSpPr>
        <p:spPr>
          <a:xfrm>
            <a:off x="4182298" y="930700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화살표 연결선 12"/>
          <p:cNvCxnSpPr/>
          <p:nvPr/>
        </p:nvCxnSpPr>
        <p:spPr>
          <a:xfrm>
            <a:off x="4512862" y="858692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화살표 연결선 13"/>
          <p:cNvCxnSpPr/>
          <p:nvPr/>
        </p:nvCxnSpPr>
        <p:spPr>
          <a:xfrm>
            <a:off x="5015847" y="1152157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화살표 연결선 14"/>
          <p:cNvCxnSpPr/>
          <p:nvPr/>
        </p:nvCxnSpPr>
        <p:spPr>
          <a:xfrm>
            <a:off x="5181129" y="1160367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화살표 연결선 15"/>
          <p:cNvCxnSpPr/>
          <p:nvPr/>
        </p:nvCxnSpPr>
        <p:spPr>
          <a:xfrm>
            <a:off x="6522464" y="921681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화살표 연결선 16"/>
          <p:cNvCxnSpPr/>
          <p:nvPr/>
        </p:nvCxnSpPr>
        <p:spPr>
          <a:xfrm>
            <a:off x="5840159" y="1026456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화살표 연결선 17"/>
          <p:cNvCxnSpPr/>
          <p:nvPr/>
        </p:nvCxnSpPr>
        <p:spPr>
          <a:xfrm>
            <a:off x="7693642" y="903137"/>
            <a:ext cx="0" cy="288000"/>
          </a:xfrm>
          <a:prstGeom prst="straightConnector1">
            <a:avLst/>
          </a:prstGeom>
          <a:ln w="63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1284723" y="96312"/>
            <a:ext cx="325730" cy="216982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10</a:t>
            </a:r>
          </a:p>
          <a:p>
            <a:endParaRPr lang="en-US" altLang="ko-KR" sz="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 9</a:t>
            </a: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 8</a:t>
            </a:r>
          </a:p>
          <a:p>
            <a:endParaRPr lang="en-US" altLang="ko-KR" sz="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7</a:t>
            </a:r>
          </a:p>
          <a:p>
            <a:endParaRPr lang="en-US" altLang="ko-KR" sz="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6</a:t>
            </a:r>
          </a:p>
          <a:p>
            <a:endParaRPr lang="en-US" altLang="ko-KR" sz="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5</a:t>
            </a:r>
          </a:p>
          <a:p>
            <a:endParaRPr lang="en-US" altLang="ko-KR" sz="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4</a:t>
            </a:r>
          </a:p>
          <a:p>
            <a:endParaRPr lang="en-US" altLang="ko-KR" sz="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2</a:t>
            </a:r>
          </a:p>
          <a:p>
            <a:endParaRPr lang="en-US" altLang="ko-KR" sz="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1</a:t>
            </a:r>
          </a:p>
          <a:p>
            <a:endParaRPr lang="en-US" altLang="ko-KR" sz="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0" name="표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8802077"/>
              </p:ext>
            </p:extLst>
          </p:nvPr>
        </p:nvGraphicFramePr>
        <p:xfrm>
          <a:off x="179512" y="2743442"/>
          <a:ext cx="2699793" cy="3670557"/>
        </p:xfrm>
        <a:graphic>
          <a:graphicData uri="http://schemas.openxmlformats.org/drawingml/2006/table">
            <a:tbl>
              <a:tblPr/>
              <a:tblGrid>
                <a:gridCol w="89993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9993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9993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7612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mpounds</a:t>
                      </a:r>
                      <a:endParaRPr lang="ko-KR" alt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442A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T3-L1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MSO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henamil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76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W784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ko-KR" alt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4689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7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76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1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3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5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 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8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19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7612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3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797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4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6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27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3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799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34</a:t>
                      </a: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+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-</a:t>
                      </a:r>
                      <a:endParaRPr lang="en-US" altLang="ko-KR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163" marR="4163" marT="416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</a:tbl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351273" y="6417714"/>
            <a:ext cx="2582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+ ; Increase lipid accumulation,  -  ; No effects</a:t>
            </a:r>
            <a:endParaRPr lang="ko-KR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22" name="표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49518959"/>
              </p:ext>
            </p:extLst>
          </p:nvPr>
        </p:nvGraphicFramePr>
        <p:xfrm>
          <a:off x="2972539" y="2722545"/>
          <a:ext cx="2088232" cy="2016224"/>
        </p:xfrm>
        <a:graphic>
          <a:graphicData uri="http://schemas.openxmlformats.org/drawingml/2006/table">
            <a:tbl>
              <a:tblPr/>
              <a:tblGrid>
                <a:gridCol w="92789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6033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052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Compound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smtClean="0">
                          <a:latin typeface="Times New Roman" pitchFamily="18" charset="0"/>
                          <a:cs typeface="Times New Roman" pitchFamily="18" charset="0"/>
                        </a:rPr>
                        <a:t>Activity </a:t>
                      </a:r>
                      <a:r>
                        <a:rPr lang="en-US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(%)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44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DMSO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44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 err="1">
                          <a:latin typeface="Times New Roman" pitchFamily="18" charset="0"/>
                          <a:cs typeface="Times New Roman" pitchFamily="18" charset="0"/>
                        </a:rPr>
                        <a:t>Rosi</a:t>
                      </a:r>
                      <a:endParaRPr lang="en-US" sz="900" b="0" i="0" u="none" strike="noStrike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100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844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T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56.67 +/- 12.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52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T2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71.57 +/- 3.4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052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PT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69.93 +/- 8.18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052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T7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15.27 +/- 6.05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052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latin typeface="Times New Roman" pitchFamily="18" charset="0"/>
                          <a:cs typeface="Times New Roman" pitchFamily="18" charset="0"/>
                        </a:rPr>
                        <a:t>PT13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0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47.032 +/- 5.99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5237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T2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24.16 +/- 7.41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3750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PT26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900" b="1" i="0" u="none" strike="noStrike" dirty="0">
                          <a:latin typeface="Times New Roman" pitchFamily="18" charset="0"/>
                          <a:cs typeface="Times New Roman" pitchFamily="18" charset="0"/>
                        </a:rPr>
                        <a:t>20.28+/- 3.04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sp>
        <p:nvSpPr>
          <p:cNvPr id="23" name="TextBox 22"/>
          <p:cNvSpPr txBox="1"/>
          <p:nvPr/>
        </p:nvSpPr>
        <p:spPr>
          <a:xfrm>
            <a:off x="2040225" y="2061326"/>
            <a:ext cx="62440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1   2    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3   4   5  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6    7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   8   9  10 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11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 12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13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 14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15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 16  17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18  19 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20 21 22 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23 24 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25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26 27  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28 29 30  31 32 </a:t>
            </a:r>
            <a:r>
              <a:rPr lang="en-US" altLang="ko-KR" sz="1000" b="1" dirty="0" smtClean="0">
                <a:latin typeface="Times New Roman" pitchFamily="18" charset="0"/>
                <a:cs typeface="Times New Roman" pitchFamily="18" charset="0"/>
              </a:rPr>
              <a:t>33  34 </a:t>
            </a:r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35 </a:t>
            </a:r>
            <a:endParaRPr lang="ko-KR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1420087" y="2154321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DMSO</a:t>
            </a:r>
            <a:endParaRPr lang="ko-KR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1526214" y="2183797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err="1" smtClean="0">
                <a:latin typeface="Times New Roman" pitchFamily="18" charset="0"/>
                <a:cs typeface="Times New Roman" pitchFamily="18" charset="0"/>
              </a:rPr>
              <a:t>Phenamil</a:t>
            </a:r>
            <a:endParaRPr lang="ko-KR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1706292" y="2200595"/>
            <a:ext cx="6559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Times New Roman" pitchFamily="18" charset="0"/>
                <a:cs typeface="Times New Roman" pitchFamily="18" charset="0"/>
              </a:rPr>
              <a:t>GW7845</a:t>
            </a:r>
            <a:endParaRPr lang="ko-KR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2" name="직선 연결선 31"/>
          <p:cNvCxnSpPr/>
          <p:nvPr/>
        </p:nvCxnSpPr>
        <p:spPr>
          <a:xfrm>
            <a:off x="2147885" y="2287950"/>
            <a:ext cx="57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247270" y="2275341"/>
            <a:ext cx="1110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PT compounds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 rot="16200000">
            <a:off x="295943" y="1004406"/>
            <a:ext cx="16408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" name="그룹 29"/>
          <p:cNvGrpSpPr>
            <a:grpSpLocks noChangeAspect="1"/>
          </p:cNvGrpSpPr>
          <p:nvPr/>
        </p:nvGrpSpPr>
        <p:grpSpPr>
          <a:xfrm>
            <a:off x="5148064" y="2742580"/>
            <a:ext cx="3783097" cy="3785652"/>
            <a:chOff x="5436096" y="2974300"/>
            <a:chExt cx="4450706" cy="4453708"/>
          </a:xfrm>
        </p:grpSpPr>
        <p:grpSp>
          <p:nvGrpSpPr>
            <p:cNvPr id="28" name="그룹 30"/>
            <p:cNvGrpSpPr/>
            <p:nvPr/>
          </p:nvGrpSpPr>
          <p:grpSpPr>
            <a:xfrm>
              <a:off x="5436096" y="2974300"/>
              <a:ext cx="4450706" cy="4453708"/>
              <a:chOff x="5635936" y="3068960"/>
              <a:chExt cx="4450706" cy="4453708"/>
            </a:xfrm>
          </p:grpSpPr>
          <p:sp>
            <p:nvSpPr>
              <p:cNvPr id="36" name="TextBox 35"/>
              <p:cNvSpPr txBox="1"/>
              <p:nvPr/>
            </p:nvSpPr>
            <p:spPr>
              <a:xfrm>
                <a:off x="5635936" y="3068960"/>
                <a:ext cx="4450706" cy="445370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High throughput screening (160,000 compounds tested)</a:t>
                </a: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Ppar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  <a:sym typeface="Symbol"/>
                  </a:rPr>
                  <a:t>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 expression (35 compounds selected)</a:t>
                </a: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Adipoyte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 differentiation –oil red O staining (15 compounds selected)</a:t>
                </a: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Ppar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  <a:sym typeface="Symbol"/>
                  </a:rPr>
                  <a:t>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ligand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 –like activities (7 compounds selected)</a:t>
                </a: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Microarray analysis of candidates (3 compounds selected)</a:t>
                </a: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overlapped genes induced by 3 compounds </a:t>
                </a: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endParaRPr lang="en-US" altLang="ko-KR" sz="1200" dirty="0" smtClean="0">
                  <a:latin typeface="Times New Roman" pitchFamily="18" charset="0"/>
                  <a:cs typeface="Times New Roman" pitchFamily="18" charset="0"/>
                </a:endParaRPr>
              </a:p>
              <a:p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Identification of genes (</a:t>
                </a:r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Ppar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  <a:sym typeface="Symbol" panose="05050102010706020507" pitchFamily="18" charset="2"/>
                  </a:rPr>
                  <a:t>,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 Gipc2, Ccl9, and </a:t>
                </a:r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Cfd</a:t>
                </a:r>
                <a:r>
                  <a:rPr lang="en-US" altLang="ko-KR" sz="1200" dirty="0" smtClean="0">
                    <a:latin typeface="Times New Roman" pitchFamily="18" charset="0"/>
                    <a:cs typeface="Times New Roman" pitchFamily="18" charset="0"/>
                  </a:rPr>
                  <a:t>)</a:t>
                </a:r>
                <a:endParaRPr lang="ko-KR" altLang="en-US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37" name="직선 화살표 연결선 36"/>
              <p:cNvCxnSpPr/>
              <p:nvPr/>
            </p:nvCxnSpPr>
            <p:spPr>
              <a:xfrm>
                <a:off x="6356016" y="3356992"/>
                <a:ext cx="0" cy="2880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직선 화살표 연결선 37"/>
              <p:cNvCxnSpPr/>
              <p:nvPr/>
            </p:nvCxnSpPr>
            <p:spPr>
              <a:xfrm>
                <a:off x="6364108" y="4054246"/>
                <a:ext cx="0" cy="2880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직선 화살표 연결선 38"/>
              <p:cNvCxnSpPr/>
              <p:nvPr/>
            </p:nvCxnSpPr>
            <p:spPr>
              <a:xfrm>
                <a:off x="6364108" y="4946848"/>
                <a:ext cx="0" cy="2880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직선 화살표 연결선 39"/>
              <p:cNvCxnSpPr/>
              <p:nvPr/>
            </p:nvCxnSpPr>
            <p:spPr>
              <a:xfrm>
                <a:off x="6364108" y="5607289"/>
                <a:ext cx="0" cy="2880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직선 화살표 연결선 40"/>
              <p:cNvCxnSpPr/>
              <p:nvPr/>
            </p:nvCxnSpPr>
            <p:spPr>
              <a:xfrm>
                <a:off x="6364108" y="6238543"/>
                <a:ext cx="0" cy="288032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5" name="직선 화살표 연결선 34"/>
            <p:cNvCxnSpPr/>
            <p:nvPr/>
          </p:nvCxnSpPr>
          <p:spPr>
            <a:xfrm>
              <a:off x="6168810" y="6749099"/>
              <a:ext cx="0" cy="288032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3" name="TextBox 42"/>
          <p:cNvSpPr txBox="1"/>
          <p:nvPr/>
        </p:nvSpPr>
        <p:spPr>
          <a:xfrm>
            <a:off x="179512" y="235222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971600" y="3678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843808" y="237203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5220072" y="244403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79512" y="836712"/>
            <a:ext cx="8568951" cy="36625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Sup Fig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Identification of small molecule regulators of </a:t>
            </a:r>
            <a:r>
              <a:rPr lang="en-US" altLang="ko-KR" sz="1400" b="1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 expression and </a:t>
            </a:r>
            <a:r>
              <a:rPr lang="en-US" altLang="ko-KR" sz="1400" b="1" dirty="0" err="1" smtClean="0">
                <a:latin typeface="Times New Roman" pitchFamily="18" charset="0"/>
                <a:cs typeface="Times New Roman" pitchFamily="18" charset="0"/>
              </a:rPr>
              <a:t>adipogenesis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 Induction of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expression by small molecules. Thirty-five compounds (top 0.02%) were selected from 160,000 synthetic chemicals. The selected small molecules were tested for their ability of inducing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expression. 3T3-F442A cells were treated with small molecules for 24 hours and expression was measured by real time PCR.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sed on the strong effects on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ar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(&gt; 2 folds) in 24 hours, 15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ounds (arrow)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further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lected.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ar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  <a:sym typeface="Symbol"/>
              </a:rPr>
              <a:t> expression was measured by real time PCR.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The effects of small molecules on adipocyte differentiation of 3T3-F442A cells and 3T3-L1 cells. The 3T3-F442A or 3T3-L1 cells were treated with small molecules (10 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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M) during adipocyte differentiation and lipid accumulation was assessed by Oil red O staining.  GW7845 and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phenamil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were used as the control for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agonists and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inducers, respectively.  Lipid accumulation was assessed by oil red O staining followed by quantification. Above 2 folds in lipid accumulation compared to DMSO treated cells were recognized as inducers of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adipogenesis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and denoted as +. (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 Agonistic effects of small molecule candidates.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activation assays were performed in 293T cells and the agonistic effects of small molecules were compared to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rosiglitazone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. The small molecule PT7, PT24, and PT26 were finally selected. Data are presented as means +/- 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s.d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. and are representative of two independent experiments. (</a:t>
            </a:r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) A scheme for the selection of pro-</a:t>
            </a:r>
            <a:r>
              <a:rPr lang="en-US" altLang="ko-KR" sz="1400" dirty="0" err="1" smtClean="0">
                <a:latin typeface="Times New Roman" pitchFamily="18" charset="0"/>
                <a:cs typeface="Times New Roman" pitchFamily="18" charset="0"/>
              </a:rPr>
              <a:t>adipogenic</a:t>
            </a:r>
            <a:r>
              <a:rPr lang="en-US" altLang="ko-KR" sz="1400" dirty="0" smtClean="0">
                <a:latin typeface="Times New Roman" pitchFamily="18" charset="0"/>
                <a:cs typeface="Times New Roman" pitchFamily="18" charset="0"/>
              </a:rPr>
              <a:t> small molecules, PT7, PT24, and PT26.  </a:t>
            </a:r>
            <a:endParaRPr lang="ko-KR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6" descr="D:\MRLab\기타 파일\화학구조식\PT7.tif"/>
          <p:cNvPicPr preferRelativeResize="0"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8994" y="964704"/>
            <a:ext cx="2152525" cy="10287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D:\MRLab\기타 파일\화학구조식\PT24.tif"/>
          <p:cNvPicPr preferRelativeResize="0"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9234" y="2276872"/>
            <a:ext cx="2482473" cy="17489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 descr="D:\MRLab\기타 파일\화학구조식\PT26.tif"/>
          <p:cNvPicPr preferRelativeResize="0"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20048" y="2564904"/>
            <a:ext cx="2504280" cy="11128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2" descr="D:\MRLab\기타 파일\화학구조식\GW7845.tif"/>
          <p:cNvPicPr preferRelativeResize="0"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5576" y="836712"/>
            <a:ext cx="3959349" cy="140360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979712" y="332656"/>
            <a:ext cx="8627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GW7845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961384" y="332656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PT7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23728" y="2132856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PT24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884144" y="2204864"/>
            <a:ext cx="5934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PT26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3528" y="5517232"/>
            <a:ext cx="770485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up Fig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tructures of small molecules. 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Structures of GW7845, PT7, PT24, and PT26 are shown. </a:t>
            </a: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GW7845;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agonist.  PT7; 3-chloro-N-3-pyridinyl-1-benzothiophene-2-carboxamide, PT24;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N-1,3-benzodioxol-5-yl-2-(2-thienyl)-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4-quinolinecarboxamide, PT26;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3-[3-(4-fluorophenyl)</a:t>
            </a:r>
            <a:r>
              <a:rPr lang="en-US" altLang="ko-KR" sz="1200" dirty="0" err="1">
                <a:latin typeface="Times New Roman" pitchFamily="18" charset="0"/>
                <a:cs typeface="Times New Roman" pitchFamily="18" charset="0"/>
              </a:rPr>
              <a:t>acryloyl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]-4,6-dimethyl-2(1H)-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yridinone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  <a:p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59832" y="132861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ko-KR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962374" y="1339735"/>
            <a:ext cx="7436136" cy="1808826"/>
            <a:chOff x="1106390" y="3988206"/>
            <a:chExt cx="7436136" cy="1808826"/>
          </a:xfrm>
        </p:grpSpPr>
        <p:pic>
          <p:nvPicPr>
            <p:cNvPr id="4" name="Picture 2"/>
            <p:cNvPicPr preferRelativeResize="0">
              <a:picLocks noChangeAspect="1" noChangeArrowheads="1"/>
            </p:cNvPicPr>
            <p:nvPr/>
          </p:nvPicPr>
          <p:blipFill>
            <a:blip r:embed="rId2" cstate="print"/>
            <a:srcRect t="8349"/>
            <a:stretch>
              <a:fillRect/>
            </a:stretch>
          </p:blipFill>
          <p:spPr bwMode="auto">
            <a:xfrm>
              <a:off x="1199499" y="4528691"/>
              <a:ext cx="1971676" cy="8846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5" name="그룹 52"/>
            <p:cNvGrpSpPr/>
            <p:nvPr/>
          </p:nvGrpSpPr>
          <p:grpSpPr>
            <a:xfrm>
              <a:off x="3554847" y="4195018"/>
              <a:ext cx="2650594" cy="1571625"/>
              <a:chOff x="264339" y="0"/>
              <a:chExt cx="2695575" cy="1571625"/>
            </a:xfrm>
          </p:grpSpPr>
          <p:graphicFrame>
            <p:nvGraphicFramePr>
              <p:cNvPr id="24" name="차트 23"/>
              <p:cNvGraphicFramePr/>
              <p:nvPr>
                <p:extLst>
                  <p:ext uri="{D42A27DB-BD31-4B8C-83A1-F6EECF244321}">
                    <p14:modId xmlns:p14="http://schemas.microsoft.com/office/powerpoint/2010/main" val="4113797872"/>
                  </p:ext>
                </p:extLst>
              </p:nvPr>
            </p:nvGraphicFramePr>
            <p:xfrm>
              <a:off x="264339" y="0"/>
              <a:ext cx="2695575" cy="15716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25" name="TextBox 8"/>
              <p:cNvSpPr txBox="1"/>
              <p:nvPr/>
            </p:nvSpPr>
            <p:spPr>
              <a:xfrm>
                <a:off x="594014" y="151535"/>
                <a:ext cx="645370" cy="307777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squar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i="1" dirty="0" err="1" smtClean="0">
                    <a:latin typeface="Times New Roman" pitchFamily="18" charset="0"/>
                    <a:cs typeface="Times New Roman" pitchFamily="18" charset="0"/>
                  </a:rPr>
                  <a:t>Cfd</a:t>
                </a:r>
                <a:endParaRPr lang="ko-KR" alt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6" name="그룹 24"/>
            <p:cNvGrpSpPr/>
            <p:nvPr/>
          </p:nvGrpSpPr>
          <p:grpSpPr>
            <a:xfrm>
              <a:off x="1420269" y="4185643"/>
              <a:ext cx="1630885" cy="1452673"/>
              <a:chOff x="1118349" y="906187"/>
              <a:chExt cx="1720844" cy="1532802"/>
            </a:xfrm>
          </p:grpSpPr>
          <p:sp>
            <p:nvSpPr>
              <p:cNvPr id="21" name="직사각형 20"/>
              <p:cNvSpPr/>
              <p:nvPr/>
            </p:nvSpPr>
            <p:spPr>
              <a:xfrm>
                <a:off x="1497234" y="906187"/>
                <a:ext cx="971216" cy="29227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>
                    <a:latin typeface="Times New Roman" pitchFamily="18" charset="0"/>
                    <a:cs typeface="Times New Roman" pitchFamily="18" charset="0"/>
                  </a:rPr>
                  <a:t>C3H10T1/2</a:t>
                </a:r>
              </a:p>
            </p:txBody>
          </p:sp>
          <p:sp>
            <p:nvSpPr>
              <p:cNvPr id="22" name="직사각형 21"/>
              <p:cNvSpPr/>
              <p:nvPr/>
            </p:nvSpPr>
            <p:spPr>
              <a:xfrm>
                <a:off x="1118349" y="2146711"/>
                <a:ext cx="465480" cy="29227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pBp</a:t>
                </a:r>
                <a:endParaRPr lang="en-US" altLang="ko-KR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" name="직사각형 22"/>
              <p:cNvSpPr/>
              <p:nvPr/>
            </p:nvSpPr>
            <p:spPr>
              <a:xfrm>
                <a:off x="2076022" y="2140364"/>
                <a:ext cx="763171" cy="292278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1200" dirty="0" err="1" smtClean="0">
                    <a:latin typeface="Times New Roman" pitchFamily="18" charset="0"/>
                    <a:cs typeface="Times New Roman" pitchFamily="18" charset="0"/>
                  </a:rPr>
                  <a:t>pBp-Cfd</a:t>
                </a:r>
                <a:endParaRPr lang="en-US" altLang="ko-KR" sz="12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7" name="그룹 32"/>
            <p:cNvGrpSpPr/>
            <p:nvPr/>
          </p:nvGrpSpPr>
          <p:grpSpPr>
            <a:xfrm>
              <a:off x="5817326" y="4192545"/>
              <a:ext cx="2725200" cy="1587600"/>
              <a:chOff x="0" y="0"/>
              <a:chExt cx="2695575" cy="1571625"/>
            </a:xfrm>
          </p:grpSpPr>
          <p:graphicFrame>
            <p:nvGraphicFramePr>
              <p:cNvPr id="19" name="차트 18"/>
              <p:cNvGraphicFramePr/>
              <p:nvPr>
                <p:extLst>
                  <p:ext uri="{D42A27DB-BD31-4B8C-83A1-F6EECF244321}">
                    <p14:modId xmlns:p14="http://schemas.microsoft.com/office/powerpoint/2010/main" val="3396539748"/>
                  </p:ext>
                </p:extLst>
              </p:nvPr>
            </p:nvGraphicFramePr>
            <p:xfrm>
              <a:off x="0" y="0"/>
              <a:ext cx="2695575" cy="15716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20" name="TextBox 4"/>
              <p:cNvSpPr txBox="1"/>
              <p:nvPr/>
            </p:nvSpPr>
            <p:spPr>
              <a:xfrm>
                <a:off x="333374" y="123825"/>
                <a:ext cx="1001264" cy="304680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square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400" i="1" dirty="0" err="1" smtClean="0">
                    <a:latin typeface="Times New Roman" pitchFamily="18" charset="0"/>
                    <a:cs typeface="Times New Roman" pitchFamily="18" charset="0"/>
                  </a:rPr>
                  <a:t>Ppar</a:t>
                </a:r>
                <a:r>
                  <a:rPr lang="el-GR" altLang="ko-KR" sz="1400" i="1" dirty="0" smtClean="0">
                    <a:latin typeface="Times New Roman" pitchFamily="18" charset="0"/>
                    <a:ea typeface="맑은 고딕"/>
                    <a:cs typeface="Times New Roman" pitchFamily="18" charset="0"/>
                  </a:rPr>
                  <a:t>γ</a:t>
                </a:r>
                <a:endParaRPr lang="ko-KR" altLang="en-US" sz="1400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8" name="TextBox 7"/>
            <p:cNvSpPr txBox="1"/>
            <p:nvPr/>
          </p:nvSpPr>
          <p:spPr>
            <a:xfrm>
              <a:off x="1106390" y="398820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ko-KR" alt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2648961" y="4776462"/>
              <a:ext cx="1640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itchFamily="18" charset="0"/>
                  <a:cs typeface="Times New Roman" pitchFamily="18" charset="0"/>
                </a:rPr>
                <a:t>mRNA expression</a:t>
              </a:r>
              <a:endParaRPr lang="ko-KR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0" name="직선 연결선 9"/>
            <p:cNvCxnSpPr/>
            <p:nvPr/>
          </p:nvCxnSpPr>
          <p:spPr>
            <a:xfrm>
              <a:off x="1603016" y="4483675"/>
              <a:ext cx="13147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9"/>
            <p:cNvSpPr txBox="1"/>
            <p:nvPr/>
          </p:nvSpPr>
          <p:spPr>
            <a:xfrm>
              <a:off x="4196962" y="5509010"/>
              <a:ext cx="261610" cy="27699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20"/>
            <p:cNvSpPr txBox="1"/>
            <p:nvPr/>
          </p:nvSpPr>
          <p:spPr>
            <a:xfrm>
              <a:off x="5166220" y="5518535"/>
              <a:ext cx="663964" cy="27699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8</a:t>
              </a:r>
              <a:r>
                <a:rPr lang="en-US" altLang="ko-KR" sz="1200" baseline="0" dirty="0" smtClean="0">
                  <a:latin typeface="Times New Roman" pitchFamily="18" charset="0"/>
                  <a:cs typeface="Times New Roman" pitchFamily="18" charset="0"/>
                </a:rPr>
                <a:t>  (day)</a:t>
              </a:r>
              <a:endParaRPr lang="ko-KR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9"/>
            <p:cNvSpPr txBox="1"/>
            <p:nvPr/>
          </p:nvSpPr>
          <p:spPr>
            <a:xfrm>
              <a:off x="6493267" y="5520033"/>
              <a:ext cx="261610" cy="27699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0</a:t>
              </a:r>
              <a:endParaRPr lang="ko-KR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20"/>
            <p:cNvSpPr txBox="1"/>
            <p:nvPr/>
          </p:nvSpPr>
          <p:spPr>
            <a:xfrm>
              <a:off x="7448565" y="5515598"/>
              <a:ext cx="663964" cy="276999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8</a:t>
              </a:r>
              <a:r>
                <a:rPr lang="en-US" altLang="ko-KR" sz="1200" baseline="0" dirty="0" smtClean="0">
                  <a:latin typeface="Times New Roman" pitchFamily="18" charset="0"/>
                  <a:cs typeface="Times New Roman" pitchFamily="18" charset="0"/>
                </a:rPr>
                <a:t>  (day)</a:t>
              </a:r>
              <a:endParaRPr lang="ko-KR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195861" y="4319518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275003" y="4437540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*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558638" y="4202397"/>
              <a:ext cx="3257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ko-KR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666171" y="5108672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7" name="직사각형 26"/>
          <p:cNvSpPr/>
          <p:nvPr/>
        </p:nvSpPr>
        <p:spPr>
          <a:xfrm>
            <a:off x="4867066" y="1288233"/>
            <a:ext cx="216024" cy="14401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직사각형 27"/>
          <p:cNvSpPr/>
          <p:nvPr/>
        </p:nvSpPr>
        <p:spPr>
          <a:xfrm>
            <a:off x="5605989" y="1279268"/>
            <a:ext cx="216024" cy="144016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5039086" y="1213218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776900" y="1217320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-Cfd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4813902" y="1196752"/>
            <a:ext cx="1728192" cy="31813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3896" y="3916213"/>
            <a:ext cx="904460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up Fig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C.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table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overexpression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 of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Cfd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 promotes lipid accumulation and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adipocyte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 differentiation in C3H10T1/2 cells.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C3H10T1/2 cells were infected with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abe-puro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empty vector (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or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abe-Cf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gene harboring retrovirus (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-Cf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and stable pools selected using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uromycin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2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ug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/ml) for 2 weeks.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Stable cells were differentiated into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cyte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for 8 days and Oil red O staining was performed.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Expression of </a:t>
            </a:r>
            <a:r>
              <a:rPr lang="en-US" altLang="ko-KR" sz="1200" i="1" dirty="0" err="1" smtClean="0">
                <a:latin typeface="Times New Roman" pitchFamily="18" charset="0"/>
                <a:cs typeface="Times New Roman" pitchFamily="18" charset="0"/>
              </a:rPr>
              <a:t>Cf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cyt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markers was measured on day 0 and day 8 of differentiation by real time PCR analysis. Data are presented as means +/-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.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and are representative of two independent experiments. Statistical significance was determined relative to a control by the Student’s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-test (* P&lt;0.05; ** P&lt;0.005; *** P&lt;0.0005).</a:t>
            </a:r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1"/>
          <p:cNvGrpSpPr/>
          <p:nvPr/>
        </p:nvGrpSpPr>
        <p:grpSpPr>
          <a:xfrm>
            <a:off x="1238529" y="2147331"/>
            <a:ext cx="3045439" cy="1589446"/>
            <a:chOff x="4355976" y="388361"/>
            <a:chExt cx="3045439" cy="1589446"/>
          </a:xfrm>
        </p:grpSpPr>
        <p:sp>
          <p:nvSpPr>
            <p:cNvPr id="13" name="TextBox 12"/>
            <p:cNvSpPr txBox="1"/>
            <p:nvPr/>
          </p:nvSpPr>
          <p:spPr>
            <a:xfrm>
              <a:off x="4736948" y="1700808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cr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688479" y="1700481"/>
              <a:ext cx="5132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#1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696591" y="1700481"/>
              <a:ext cx="5132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h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#2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736761" y="450012"/>
              <a:ext cx="12923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3aR knockdown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355976" y="388361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ko-KR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" name="Picture 2"/>
            <p:cNvPicPr preferRelativeResize="0"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4462951" y="764704"/>
              <a:ext cx="2938464" cy="10072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19" name="직선 연결선 18"/>
            <p:cNvCxnSpPr/>
            <p:nvPr/>
          </p:nvCxnSpPr>
          <p:spPr>
            <a:xfrm>
              <a:off x="5850214" y="719826"/>
              <a:ext cx="11166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" name="그룹 19"/>
          <p:cNvGrpSpPr/>
          <p:nvPr/>
        </p:nvGrpSpPr>
        <p:grpSpPr>
          <a:xfrm>
            <a:off x="5220072" y="1857006"/>
            <a:ext cx="2586706" cy="290325"/>
            <a:chOff x="4845195" y="1771306"/>
            <a:chExt cx="2586706" cy="290325"/>
          </a:xfrm>
        </p:grpSpPr>
        <p:sp>
          <p:nvSpPr>
            <p:cNvPr id="21" name="TextBox 20"/>
            <p:cNvSpPr txBox="1"/>
            <p:nvPr/>
          </p:nvSpPr>
          <p:spPr>
            <a:xfrm>
              <a:off x="5580112" y="1776545"/>
              <a:ext cx="18517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C3aR sh#1        C3aR sh#2</a:t>
              </a:r>
              <a:endParaRPr lang="ko-KR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4895383" y="1858857"/>
              <a:ext cx="216024" cy="144016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5436096" y="1858857"/>
              <a:ext cx="216024" cy="14401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4" name="직사각형 23"/>
            <p:cNvSpPr/>
            <p:nvPr/>
          </p:nvSpPr>
          <p:spPr>
            <a:xfrm>
              <a:off x="6372200" y="1858857"/>
              <a:ext cx="216024" cy="144016"/>
            </a:xfrm>
            <a:prstGeom prst="rect">
              <a:avLst/>
            </a:prstGeom>
            <a:solidFill>
              <a:schemeClr val="tx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080520" y="1771306"/>
              <a:ext cx="3642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err="1" smtClean="0">
                  <a:latin typeface="Times New Roman" pitchFamily="18" charset="0"/>
                  <a:cs typeface="Times New Roman" pitchFamily="18" charset="0"/>
                </a:rPr>
                <a:t>scr</a:t>
              </a:r>
              <a:endParaRPr lang="ko-KR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직사각형 25"/>
            <p:cNvSpPr/>
            <p:nvPr/>
          </p:nvSpPr>
          <p:spPr>
            <a:xfrm>
              <a:off x="4845195" y="1786332"/>
              <a:ext cx="2560568" cy="275299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4" name="그룹 26"/>
          <p:cNvGrpSpPr/>
          <p:nvPr/>
        </p:nvGrpSpPr>
        <p:grpSpPr>
          <a:xfrm>
            <a:off x="4762769" y="2123699"/>
            <a:ext cx="2871442" cy="1905000"/>
            <a:chOff x="4762769" y="2391986"/>
            <a:chExt cx="2871442" cy="1905000"/>
          </a:xfrm>
        </p:grpSpPr>
        <p:sp>
          <p:nvSpPr>
            <p:cNvPr id="28" name="TextBox 27"/>
            <p:cNvSpPr txBox="1"/>
            <p:nvPr/>
          </p:nvSpPr>
          <p:spPr>
            <a:xfrm rot="16200000">
              <a:off x="4123652" y="3139480"/>
              <a:ext cx="15552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sorbance(520 nm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9" name="차트 2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82518369"/>
                </p:ext>
              </p:extLst>
            </p:nvPr>
          </p:nvGraphicFramePr>
          <p:xfrm>
            <a:off x="4976736" y="2391986"/>
            <a:ext cx="2657475" cy="1905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sp>
        <p:nvSpPr>
          <p:cNvPr id="30" name="TextBox 29"/>
          <p:cNvSpPr txBox="1"/>
          <p:nvPr/>
        </p:nvSpPr>
        <p:spPr>
          <a:xfrm>
            <a:off x="6312759" y="2866188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006498" y="2838773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403648" y="207810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699156" y="184482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62069" y="4984853"/>
            <a:ext cx="903649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up Fig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D.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Knockdown of C3aR suppresses adipocyte differentiation of 3T3-L1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preadipocyte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Stable 3T3-L1 cells expressing control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hRNA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cr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or C3aR-targeting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hRNA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sh#1, sh#2) were generated and differentiated into adipocytes for 7 days.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Knockdown of C3aR with two independent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hRNA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decreased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cyt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differentiation in 3T3-L1 cells as assessed by oil red O staining.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Lipid accumulation was quantified. Data are presented as means +/-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.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and are representative of two independent experiments. Statistical significance was determined relative to a control by the Student’s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-test (* P&lt;0.05; ** P&lt;0.005; *** P&lt;0.0005).</a:t>
            </a:r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TextBox 128"/>
          <p:cNvSpPr txBox="1"/>
          <p:nvPr/>
        </p:nvSpPr>
        <p:spPr>
          <a:xfrm>
            <a:off x="1483192" y="46649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2" name="차트 5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31784913"/>
              </p:ext>
            </p:extLst>
          </p:nvPr>
        </p:nvGraphicFramePr>
        <p:xfrm>
          <a:off x="1565882" y="3131756"/>
          <a:ext cx="216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3" name="차트 5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9736771"/>
              </p:ext>
            </p:extLst>
          </p:nvPr>
        </p:nvGraphicFramePr>
        <p:xfrm>
          <a:off x="3676656" y="3131756"/>
          <a:ext cx="216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4" name="TextBox 53"/>
          <p:cNvSpPr txBox="1"/>
          <p:nvPr/>
        </p:nvSpPr>
        <p:spPr>
          <a:xfrm>
            <a:off x="1421866" y="3126322"/>
            <a:ext cx="26161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8</a:t>
            </a: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4</a:t>
            </a:r>
          </a:p>
          <a:p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549623" y="3161491"/>
            <a:ext cx="26161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2</a:t>
            </a:r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1</a:t>
            </a:r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오른쪽 대괄호 56"/>
          <p:cNvSpPr/>
          <p:nvPr/>
        </p:nvSpPr>
        <p:spPr>
          <a:xfrm rot="16200000">
            <a:off x="2108457" y="3816369"/>
            <a:ext cx="113529" cy="470011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8" name="오른쪽 대괄호 57"/>
          <p:cNvSpPr/>
          <p:nvPr/>
        </p:nvSpPr>
        <p:spPr>
          <a:xfrm rot="16200000">
            <a:off x="3056589" y="3296407"/>
            <a:ext cx="113529" cy="470011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6" name="오른쪽 대괄호 65"/>
          <p:cNvSpPr/>
          <p:nvPr/>
        </p:nvSpPr>
        <p:spPr>
          <a:xfrm rot="16200000">
            <a:off x="4267870" y="3354514"/>
            <a:ext cx="113529" cy="470011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오른쪽 대괄호 66"/>
          <p:cNvSpPr/>
          <p:nvPr/>
        </p:nvSpPr>
        <p:spPr>
          <a:xfrm rot="16200000">
            <a:off x="5172665" y="3178230"/>
            <a:ext cx="113529" cy="470011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8" name="TextBox 67"/>
          <p:cNvSpPr txBox="1"/>
          <p:nvPr/>
        </p:nvSpPr>
        <p:spPr>
          <a:xfrm>
            <a:off x="1980000" y="397098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934034" y="339492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156412" y="3538936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038438" y="330527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 rot="16200000">
            <a:off x="498821" y="3599664"/>
            <a:ext cx="16408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625619" y="4447179"/>
            <a:ext cx="29594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3aR agonist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-            +          -           +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913194" y="4436146"/>
            <a:ext cx="1729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           +          -           +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직사각형 88"/>
          <p:cNvSpPr/>
          <p:nvPr/>
        </p:nvSpPr>
        <p:spPr>
          <a:xfrm>
            <a:off x="3833076" y="2830429"/>
            <a:ext cx="216024" cy="14401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직사각형 89"/>
          <p:cNvSpPr/>
          <p:nvPr/>
        </p:nvSpPr>
        <p:spPr>
          <a:xfrm>
            <a:off x="4571999" y="2821464"/>
            <a:ext cx="216024" cy="144016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005096" y="2755414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742910" y="2759516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-Cfd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직사각형 92"/>
          <p:cNvSpPr/>
          <p:nvPr/>
        </p:nvSpPr>
        <p:spPr>
          <a:xfrm>
            <a:off x="3779912" y="2738948"/>
            <a:ext cx="1728192" cy="31813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94" name="차트 9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9258943"/>
              </p:ext>
            </p:extLst>
          </p:nvPr>
        </p:nvGraphicFramePr>
        <p:xfrm>
          <a:off x="5880259" y="3131756"/>
          <a:ext cx="2160000" cy="14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5" name="TextBox 94"/>
          <p:cNvSpPr txBox="1"/>
          <p:nvPr/>
        </p:nvSpPr>
        <p:spPr>
          <a:xfrm>
            <a:off x="5752463" y="3161491"/>
            <a:ext cx="261610" cy="14465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6</a:t>
            </a:r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오른쪽 대괄호 95"/>
          <p:cNvSpPr/>
          <p:nvPr/>
        </p:nvSpPr>
        <p:spPr>
          <a:xfrm rot="16200000">
            <a:off x="6478826" y="3693328"/>
            <a:ext cx="113529" cy="470011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8" name="오른쪽 대괄호 97"/>
          <p:cNvSpPr/>
          <p:nvPr/>
        </p:nvSpPr>
        <p:spPr>
          <a:xfrm rot="16200000">
            <a:off x="7382685" y="3218346"/>
            <a:ext cx="113529" cy="470011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9" name="TextBox 98"/>
          <p:cNvSpPr txBox="1"/>
          <p:nvPr/>
        </p:nvSpPr>
        <p:spPr>
          <a:xfrm>
            <a:off x="6328527" y="3853863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7264631" y="335906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6112204" y="4418216"/>
            <a:ext cx="1729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            +          -           +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 rot="16200000">
            <a:off x="1423635" y="1428547"/>
            <a:ext cx="15552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orbance(520 nm)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직사각형 107"/>
          <p:cNvSpPr/>
          <p:nvPr/>
        </p:nvSpPr>
        <p:spPr>
          <a:xfrm>
            <a:off x="2896973" y="466040"/>
            <a:ext cx="216024" cy="14401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9" name="직사각형 108"/>
          <p:cNvSpPr/>
          <p:nvPr/>
        </p:nvSpPr>
        <p:spPr>
          <a:xfrm>
            <a:off x="3635896" y="457075"/>
            <a:ext cx="216024" cy="144016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068993" y="39102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806807" y="395127"/>
            <a:ext cx="7232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-Cfd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직사각형 115"/>
          <p:cNvSpPr/>
          <p:nvPr/>
        </p:nvSpPr>
        <p:spPr>
          <a:xfrm>
            <a:off x="2843809" y="374559"/>
            <a:ext cx="1728192" cy="318137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187624" y="2708920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3" name="차트 1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05959267"/>
              </p:ext>
            </p:extLst>
          </p:nvPr>
        </p:nvGraphicFramePr>
        <p:xfrm>
          <a:off x="2414235" y="542970"/>
          <a:ext cx="2661821" cy="1949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4" name="TextBox 123"/>
          <p:cNvSpPr txBox="1"/>
          <p:nvPr/>
        </p:nvSpPr>
        <p:spPr>
          <a:xfrm>
            <a:off x="2291613" y="591942"/>
            <a:ext cx="251992" cy="18928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 smtClean="0">
                <a:latin typeface="Times New Roman" pitchFamily="18" charset="0"/>
                <a:cs typeface="Times New Roman" pitchFamily="18" charset="0"/>
              </a:rPr>
              <a:t>3</a:t>
            </a:r>
          </a:p>
          <a:p>
            <a:endParaRPr lang="en-US" altLang="ko-KR" sz="11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2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050" dirty="0" smtClean="0">
                <a:latin typeface="Times New Roman" pitchFamily="18" charset="0"/>
                <a:cs typeface="Times New Roman" pitchFamily="18" charset="0"/>
              </a:rPr>
              <a:t>2</a:t>
            </a:r>
          </a:p>
          <a:p>
            <a:endParaRPr lang="en-US" altLang="ko-KR" sz="16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050" dirty="0" smtClean="0">
                <a:latin typeface="Times New Roman" pitchFamily="18" charset="0"/>
                <a:cs typeface="Times New Roman" pitchFamily="18" charset="0"/>
              </a:rPr>
              <a:t>1</a:t>
            </a:r>
          </a:p>
          <a:p>
            <a:endParaRPr lang="en-US" altLang="ko-KR" sz="14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altLang="ko-KR" sz="11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050" dirty="0" smtClean="0">
                <a:latin typeface="Times New Roman" pitchFamily="18" charset="0"/>
                <a:cs typeface="Times New Roman" pitchFamily="18" charset="0"/>
              </a:rPr>
              <a:t>0</a:t>
            </a:r>
            <a:endParaRPr lang="ko-KR" altLang="en-US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오른쪽 대괄호 124"/>
          <p:cNvSpPr/>
          <p:nvPr/>
        </p:nvSpPr>
        <p:spPr>
          <a:xfrm rot="16200000">
            <a:off x="3054925" y="1121218"/>
            <a:ext cx="113529" cy="679779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6" name="오른쪽 대괄호 125"/>
          <p:cNvSpPr/>
          <p:nvPr/>
        </p:nvSpPr>
        <p:spPr>
          <a:xfrm rot="16200000">
            <a:off x="4279061" y="765207"/>
            <a:ext cx="113529" cy="679779"/>
          </a:xfrm>
          <a:prstGeom prst="rightBracket">
            <a:avLst>
              <a:gd name="adj" fmla="val 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7" name="TextBox 126"/>
          <p:cNvSpPr txBox="1"/>
          <p:nvPr/>
        </p:nvSpPr>
        <p:spPr>
          <a:xfrm>
            <a:off x="2942912" y="1376916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144332" y="99865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1520769" y="2375436"/>
            <a:ext cx="3296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3aR agonist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-              +              -             +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5435" y="5469031"/>
            <a:ext cx="89644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up Fig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E.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C3aR activation bypasses the stimulatory actions of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Cfd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 in adipocyte differentiation of 3T3-L1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preadipocytes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Control empty vector (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or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Cf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stably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overexpresing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Bp-Cf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cells were treated with C4494 (1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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M, a C3aR agonist) and differentiated into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cyte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for 6 days. Lipid accumulation was quantified.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Expression of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cyt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markers was assessed by real time PCR. Data are presented as means +/-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.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and are representative of two independent experiments. Statistical significance was determined relative to a control by the Student’s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-test (* P&lt;0.05; ** P&lt;0.005; *** P&lt;0.0005;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not significant).</a:t>
            </a:r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461433" y="2570775"/>
            <a:ext cx="2557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cr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#1                        #2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99792" y="2204243"/>
            <a:ext cx="9957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9 siRNA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>
            <a:off x="2357682" y="2518761"/>
            <a:ext cx="1800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 rot="16200000">
            <a:off x="3876263" y="3075872"/>
            <a:ext cx="15552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orbance(520 nm)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차트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54639122"/>
              </p:ext>
            </p:extLst>
          </p:nvPr>
        </p:nvGraphicFramePr>
        <p:xfrm>
          <a:off x="4724981" y="2269429"/>
          <a:ext cx="2520280" cy="20420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5922510" y="3375365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561329" y="3240314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436949" y="2053405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87624" y="212541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259632" y="2845493"/>
            <a:ext cx="3024336" cy="9801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3" name="직사각형 12"/>
          <p:cNvSpPr/>
          <p:nvPr/>
        </p:nvSpPr>
        <p:spPr>
          <a:xfrm>
            <a:off x="5056651" y="2076391"/>
            <a:ext cx="216024" cy="14401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직사각형 13"/>
          <p:cNvSpPr/>
          <p:nvPr/>
        </p:nvSpPr>
        <p:spPr>
          <a:xfrm>
            <a:off x="5630734" y="2076391"/>
            <a:ext cx="216024" cy="144016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직사각형 15"/>
          <p:cNvSpPr/>
          <p:nvPr/>
        </p:nvSpPr>
        <p:spPr>
          <a:xfrm>
            <a:off x="6516216" y="2076391"/>
            <a:ext cx="216024" cy="144016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/>
          <p:cNvSpPr txBox="1"/>
          <p:nvPr/>
        </p:nvSpPr>
        <p:spPr>
          <a:xfrm>
            <a:off x="5241788" y="1988840"/>
            <a:ext cx="3642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cr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5796136" y="1994079"/>
            <a:ext cx="17043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Ccl9 si#1        Ccl9 si#2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5021300" y="2002502"/>
            <a:ext cx="2376264" cy="275553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/>
          <p:cNvSpPr txBox="1"/>
          <p:nvPr/>
        </p:nvSpPr>
        <p:spPr>
          <a:xfrm>
            <a:off x="117443" y="5445224"/>
            <a:ext cx="882047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up Fig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F.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ilencing of Ccl9 suppresses adipocyte differentiation of C3H10T1/2 cell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C3H10T1/2 cells were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with control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iRNA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cr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or Ccl9-targeting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iRNA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si#1, si#2) and differentiated into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cyte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for 10 days.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Knockdown of Ccl9 with two independent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iRNA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decreased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adipocyte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differentiation in C3H10T1/2 cells as assessed by oil red O staining.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Lipid accumulation was quantified. Statistically significant differences were determined by Student’s t-test (*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&lt; 0.05; **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&lt; 0.005; ***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P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&lt; 0.0005).</a:t>
            </a:r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51076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차트 2"/>
          <p:cNvGraphicFramePr/>
          <p:nvPr/>
        </p:nvGraphicFramePr>
        <p:xfrm>
          <a:off x="861742" y="33518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직사각형 4"/>
          <p:cNvSpPr/>
          <p:nvPr/>
        </p:nvSpPr>
        <p:spPr>
          <a:xfrm>
            <a:off x="2445918" y="672467"/>
            <a:ext cx="216024" cy="14401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직사각형 5"/>
          <p:cNvSpPr/>
          <p:nvPr/>
        </p:nvSpPr>
        <p:spPr>
          <a:xfrm>
            <a:off x="3321889" y="648717"/>
            <a:ext cx="216024" cy="144016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TextBox 7"/>
          <p:cNvSpPr txBox="1"/>
          <p:nvPr/>
        </p:nvSpPr>
        <p:spPr>
          <a:xfrm>
            <a:off x="2631055" y="564076"/>
            <a:ext cx="62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DMSO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577028" y="572225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GW7845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2312535" y="549717"/>
            <a:ext cx="2221615" cy="320606"/>
          </a:xfrm>
          <a:prstGeom prst="rect">
            <a:avLst/>
          </a:prstGeom>
          <a:noFill/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" name="TextBox 10"/>
          <p:cNvSpPr txBox="1"/>
          <p:nvPr/>
        </p:nvSpPr>
        <p:spPr>
          <a:xfrm>
            <a:off x="1293790" y="1043656"/>
            <a:ext cx="5245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i="1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100" i="1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endParaRPr lang="ko-KR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261247" y="3510070"/>
            <a:ext cx="4122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i="1" dirty="0" smtClean="0">
                <a:latin typeface="Times New Roman" pitchFamily="18" charset="0"/>
                <a:cs typeface="Times New Roman" pitchFamily="18" charset="0"/>
              </a:rPr>
              <a:t>aP2</a:t>
            </a:r>
            <a:endParaRPr lang="ko-KR" altLang="en-US" sz="11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425931" y="6248345"/>
            <a:ext cx="36663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DMSO                    PT7                  PT24                 PT26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직선 연결선 14"/>
          <p:cNvCxnSpPr/>
          <p:nvPr/>
        </p:nvCxnSpPr>
        <p:spPr>
          <a:xfrm>
            <a:off x="1329415" y="6220590"/>
            <a:ext cx="8640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직선 연결선 15"/>
          <p:cNvCxnSpPr/>
          <p:nvPr/>
        </p:nvCxnSpPr>
        <p:spPr>
          <a:xfrm>
            <a:off x="2350160" y="6220590"/>
            <a:ext cx="8640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직선 연결선 16"/>
          <p:cNvCxnSpPr/>
          <p:nvPr/>
        </p:nvCxnSpPr>
        <p:spPr>
          <a:xfrm>
            <a:off x="3333764" y="6219832"/>
            <a:ext cx="8640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직선 연결선 17"/>
          <p:cNvCxnSpPr/>
          <p:nvPr/>
        </p:nvCxnSpPr>
        <p:spPr>
          <a:xfrm>
            <a:off x="4365626" y="6220590"/>
            <a:ext cx="86409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29694" y="5960313"/>
            <a:ext cx="49167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GW7845         -            +            -           +            -           +           -            +   </a:t>
            </a:r>
            <a:endParaRPr lang="ko-KR" altLang="en-US" sz="12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그룹 24"/>
          <p:cNvGrpSpPr/>
          <p:nvPr/>
        </p:nvGrpSpPr>
        <p:grpSpPr>
          <a:xfrm>
            <a:off x="2499429" y="1403696"/>
            <a:ext cx="570241" cy="171000"/>
            <a:chOff x="3851920" y="1196752"/>
            <a:chExt cx="648073" cy="254905"/>
          </a:xfrm>
        </p:grpSpPr>
        <p:cxnSp>
          <p:nvCxnSpPr>
            <p:cNvPr id="21" name="직선 연결선 20"/>
            <p:cNvCxnSpPr/>
            <p:nvPr/>
          </p:nvCxnSpPr>
          <p:spPr>
            <a:xfrm>
              <a:off x="3851921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직선 연결선 22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직선 연결선 23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그룹 25"/>
          <p:cNvGrpSpPr/>
          <p:nvPr/>
        </p:nvGrpSpPr>
        <p:grpSpPr>
          <a:xfrm>
            <a:off x="3521246" y="1187672"/>
            <a:ext cx="570240" cy="171000"/>
            <a:chOff x="3851920" y="1196752"/>
            <a:chExt cx="648072" cy="254905"/>
          </a:xfrm>
        </p:grpSpPr>
        <p:cxnSp>
          <p:nvCxnSpPr>
            <p:cNvPr id="27" name="직선 연결선 26"/>
            <p:cNvCxnSpPr/>
            <p:nvPr/>
          </p:nvCxnSpPr>
          <p:spPr>
            <a:xfrm>
              <a:off x="3851920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직선 연결선 27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직선 연결선 28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그룹 29"/>
          <p:cNvGrpSpPr/>
          <p:nvPr/>
        </p:nvGrpSpPr>
        <p:grpSpPr>
          <a:xfrm>
            <a:off x="4519558" y="1616104"/>
            <a:ext cx="570240" cy="171000"/>
            <a:chOff x="3851920" y="1196752"/>
            <a:chExt cx="648072" cy="254905"/>
          </a:xfrm>
        </p:grpSpPr>
        <p:cxnSp>
          <p:nvCxnSpPr>
            <p:cNvPr id="31" name="직선 연결선 30"/>
            <p:cNvCxnSpPr/>
            <p:nvPr/>
          </p:nvCxnSpPr>
          <p:spPr>
            <a:xfrm>
              <a:off x="3851920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직선 연결선 31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32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그룹 33"/>
          <p:cNvGrpSpPr/>
          <p:nvPr/>
        </p:nvGrpSpPr>
        <p:grpSpPr>
          <a:xfrm>
            <a:off x="1453358" y="2456832"/>
            <a:ext cx="570240" cy="171000"/>
            <a:chOff x="3851920" y="1196752"/>
            <a:chExt cx="648072" cy="254905"/>
          </a:xfrm>
        </p:grpSpPr>
        <p:cxnSp>
          <p:nvCxnSpPr>
            <p:cNvPr id="35" name="직선 연결선 34"/>
            <p:cNvCxnSpPr/>
            <p:nvPr/>
          </p:nvCxnSpPr>
          <p:spPr>
            <a:xfrm>
              <a:off x="3851920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연결선 36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0" name="그룹 37"/>
          <p:cNvGrpSpPr/>
          <p:nvPr/>
        </p:nvGrpSpPr>
        <p:grpSpPr>
          <a:xfrm>
            <a:off x="1437806" y="4942205"/>
            <a:ext cx="570240" cy="171000"/>
            <a:chOff x="3851920" y="1196752"/>
            <a:chExt cx="648072" cy="254905"/>
          </a:xfrm>
        </p:grpSpPr>
        <p:cxnSp>
          <p:nvCxnSpPr>
            <p:cNvPr id="39" name="직선 연결선 38"/>
            <p:cNvCxnSpPr/>
            <p:nvPr/>
          </p:nvCxnSpPr>
          <p:spPr>
            <a:xfrm>
              <a:off x="3851920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직선 연결선 39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직선 연결선 40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그룹 41"/>
          <p:cNvGrpSpPr/>
          <p:nvPr/>
        </p:nvGrpSpPr>
        <p:grpSpPr>
          <a:xfrm>
            <a:off x="2465374" y="3862085"/>
            <a:ext cx="570240" cy="171000"/>
            <a:chOff x="3851920" y="1196752"/>
            <a:chExt cx="648072" cy="254905"/>
          </a:xfrm>
        </p:grpSpPr>
        <p:cxnSp>
          <p:nvCxnSpPr>
            <p:cNvPr id="43" name="직선 연결선 42"/>
            <p:cNvCxnSpPr/>
            <p:nvPr/>
          </p:nvCxnSpPr>
          <p:spPr>
            <a:xfrm>
              <a:off x="3851920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직선 연결선 43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직선 연결선 44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" name="그룹 45"/>
          <p:cNvGrpSpPr/>
          <p:nvPr/>
        </p:nvGrpSpPr>
        <p:grpSpPr>
          <a:xfrm>
            <a:off x="3473486" y="3790077"/>
            <a:ext cx="570240" cy="171000"/>
            <a:chOff x="3851920" y="1196752"/>
            <a:chExt cx="648072" cy="254905"/>
          </a:xfrm>
        </p:grpSpPr>
        <p:cxnSp>
          <p:nvCxnSpPr>
            <p:cNvPr id="47" name="직선 연결선 46"/>
            <p:cNvCxnSpPr/>
            <p:nvPr/>
          </p:nvCxnSpPr>
          <p:spPr>
            <a:xfrm>
              <a:off x="3851920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직선 연결선 47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직선 연결선 48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그룹 49"/>
          <p:cNvGrpSpPr/>
          <p:nvPr/>
        </p:nvGrpSpPr>
        <p:grpSpPr>
          <a:xfrm>
            <a:off x="4495238" y="3983981"/>
            <a:ext cx="570240" cy="171000"/>
            <a:chOff x="3851920" y="1196752"/>
            <a:chExt cx="648072" cy="254905"/>
          </a:xfrm>
        </p:grpSpPr>
        <p:cxnSp>
          <p:nvCxnSpPr>
            <p:cNvPr id="51" name="직선 연결선 50"/>
            <p:cNvCxnSpPr/>
            <p:nvPr/>
          </p:nvCxnSpPr>
          <p:spPr>
            <a:xfrm>
              <a:off x="3851920" y="1196752"/>
              <a:ext cx="64807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직선 연결선 51"/>
            <p:cNvCxnSpPr/>
            <p:nvPr/>
          </p:nvCxnSpPr>
          <p:spPr>
            <a:xfrm>
              <a:off x="3851920" y="1196752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/>
            <p:cNvCxnSpPr/>
            <p:nvPr/>
          </p:nvCxnSpPr>
          <p:spPr>
            <a:xfrm>
              <a:off x="4497845" y="1199657"/>
              <a:ext cx="0" cy="25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4" name="TextBox 53"/>
          <p:cNvSpPr txBox="1"/>
          <p:nvPr/>
        </p:nvSpPr>
        <p:spPr>
          <a:xfrm>
            <a:off x="2616356" y="3862085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619532" y="3790077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663574" y="3982733"/>
            <a:ext cx="255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*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563892" y="4953238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 smtClean="0">
                <a:latin typeface="Times New Roman" pitchFamily="18" charset="0"/>
                <a:cs typeface="Times New Roman" pitchFamily="18" charset="0"/>
              </a:rPr>
              <a:t>**</a:t>
            </a:r>
            <a:endParaRPr lang="ko-KR" altLang="en-US" sz="11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524406" y="243031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609390" y="1350192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617502" y="1134168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630478" y="1562304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66" name="차트 65"/>
          <p:cNvGraphicFramePr/>
          <p:nvPr/>
        </p:nvGraphicFramePr>
        <p:xfrm>
          <a:off x="864096" y="79537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8" name="TextBox 57"/>
          <p:cNvSpPr txBox="1"/>
          <p:nvPr/>
        </p:nvSpPr>
        <p:spPr>
          <a:xfrm rot="16200000">
            <a:off x="-108195" y="1941585"/>
            <a:ext cx="16408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-108195" y="4615998"/>
            <a:ext cx="16408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</a:t>
            </a:r>
            <a:endParaRPr lang="ko-KR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5436097" y="1512074"/>
            <a:ext cx="3528392" cy="24929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Sup Fig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G.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Combinatory effects of the selected small molecules and GW7845 on </a:t>
            </a:r>
            <a:r>
              <a:rPr lang="en-US" altLang="ko-KR" sz="1200" b="1" i="1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200" b="1" i="1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ko-KR" sz="1200" b="1" i="1" dirty="0" smtClean="0">
                <a:latin typeface="Times New Roman" pitchFamily="18" charset="0"/>
                <a:cs typeface="Times New Roman" pitchFamily="18" charset="0"/>
              </a:rPr>
              <a:t>aP2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 expression in 3T3-F442A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preadipocytes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Treatment with the three selected small molecules in combination with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agonist GW7845 for 24 hours did not additively increase the expression of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par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  <a:sym typeface="Symbol"/>
              </a:rPr>
              <a:t>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itself in 3T3-F442A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preadipocyte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Combination of small molecules and GW7845 additively increased the expression of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aP2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Data are presented as means +/-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.d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and are representative of two independent experiments. Statistical significance was determined relative to a control by the Student’s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-test (* P&lt;0.05; ** P&lt;0.005;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n.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not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ignficant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ko-KR" altLang="ko-KR" sz="1200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5</TotalTime>
  <Words>1446</Words>
  <Application>Microsoft Office PowerPoint</Application>
  <PresentationFormat>On-screen Show (4:3)</PresentationFormat>
  <Paragraphs>267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맑은 고딕</vt:lpstr>
      <vt:lpstr>Arial</vt:lpstr>
      <vt:lpstr>굴림</vt:lpstr>
      <vt:lpstr>Symbol</vt:lpstr>
      <vt:lpstr>Times New Roman</vt:lpstr>
      <vt:lpstr>Office 테마</vt:lpstr>
      <vt:lpstr>Supplementary Inform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kwpark</dc:creator>
  <cp:lastModifiedBy>Kyewon Park</cp:lastModifiedBy>
  <cp:revision>71</cp:revision>
  <dcterms:created xsi:type="dcterms:W3CDTF">2014-06-16T07:08:35Z</dcterms:created>
  <dcterms:modified xsi:type="dcterms:W3CDTF">2016-08-23T18:28:01Z</dcterms:modified>
</cp:coreProperties>
</file>